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1.xml" ContentType="application/vnd.openxmlformats-officedocument.themeOverrid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4"/>
  </p:handoutMasterIdLst>
  <p:sldIdLst>
    <p:sldId id="261" r:id="rId2"/>
    <p:sldId id="281" r:id="rId3"/>
  </p:sldIdLst>
  <p:sldSz cx="43205400" cy="32404050"/>
  <p:notesSz cx="6858000" cy="9144000"/>
  <p:defaultTextStyle>
    <a:defPPr>
      <a:defRPr lang="ko-KR"/>
    </a:defPPr>
    <a:lvl1pPr marL="0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1pPr>
    <a:lvl2pPr marL="2158461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2pPr>
    <a:lvl3pPr marL="4316934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3pPr>
    <a:lvl4pPr marL="6475396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4pPr>
    <a:lvl5pPr marL="8633861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5pPr>
    <a:lvl6pPr marL="10792330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6pPr>
    <a:lvl7pPr marL="12950791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7pPr>
    <a:lvl8pPr marL="15109257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8pPr>
    <a:lvl9pPr marL="17267722" algn="l" defTabSz="4316934" rtl="0" eaLnBrk="1" latinLnBrk="1" hangingPunct="1">
      <a:defRPr sz="8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6">
          <p15:clr>
            <a:srgbClr val="A4A3A4"/>
          </p15:clr>
        </p15:guide>
        <p15:guide id="2" pos="1360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772" autoAdjust="0"/>
  </p:normalViewPr>
  <p:slideViewPr>
    <p:cSldViewPr>
      <p:cViewPr varScale="1">
        <p:scale>
          <a:sx n="17" d="100"/>
          <a:sy n="17" d="100"/>
        </p:scale>
        <p:origin x="1560" y="106"/>
      </p:cViewPr>
      <p:guideLst>
        <p:guide orient="horz" pos="10206"/>
        <p:guide pos="13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\New\LED%20&#44284;&#51228;\2020\data\paper\glucosinolate\data\&#48373;&#49324;&#48376;%201123-&#44397;&#47549;&#45453;&#50629;&#44284;&#54617;&#50896;%20&#48516;&#49437;&#44208;&#44284;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\New\LED%20&#44284;&#51228;\2020\data\paper\glucosinolate\data\&#48373;&#49324;&#48376;%201123-&#44397;&#47549;&#45453;&#50629;&#44284;&#54617;&#50896;%20&#48516;&#49437;&#44208;&#44284;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\New\LED%20&#44284;&#51228;\2020\data\paper\glucosinolate\data\&#48373;&#49324;&#48376;%201123-&#44397;&#47549;&#45453;&#50629;&#44284;&#54617;&#50896;%20&#48516;&#49437;&#44208;&#44284;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6.xlsx"/><Relationship Id="rId1" Type="http://schemas.openxmlformats.org/officeDocument/2006/relationships/themeOverride" Target="../theme/themeOverride1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\New\LED%20&#44284;&#51228;\2020\data\paper\glucosinolate\data\&#48373;&#49324;&#48376;%201123-&#44397;&#47549;&#45453;&#50629;&#44284;&#54617;&#50896;%20&#48516;&#49437;&#44208;&#44284;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E:\WORK\New\LED%20&#44284;&#51228;\2020\data\paper\glucosinolate\data\&#48373;&#49324;&#48376;%201123-&#44397;&#47549;&#45453;&#50629;&#44284;&#54617;&#50896;%20&#48516;&#49437;&#44208;&#44284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924806715795422"/>
          <c:y val="6.0659813356663747E-2"/>
          <c:w val="0.69645766809047494"/>
          <c:h val="0.477814231554389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I$26</c:f>
              <c:strCache>
                <c:ptCount val="1"/>
                <c:pt idx="0">
                  <c:v>DH03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R$27:$R$35</c:f>
                <c:numCache>
                  <c:formatCode>General</c:formatCode>
                  <c:ptCount val="9"/>
                  <c:pt idx="0">
                    <c:v>0.42799246811132874</c:v>
                  </c:pt>
                  <c:pt idx="1">
                    <c:v>0.43015342748980034</c:v>
                  </c:pt>
                  <c:pt idx="2">
                    <c:v>0.36492300059048544</c:v>
                  </c:pt>
                  <c:pt idx="3">
                    <c:v>2.2893832230181004</c:v>
                  </c:pt>
                  <c:pt idx="4">
                    <c:v>0.14892909593590151</c:v>
                  </c:pt>
                  <c:pt idx="5">
                    <c:v>2.8837860739402619E-2</c:v>
                  </c:pt>
                  <c:pt idx="6">
                    <c:v>8.2244118207885172E-2</c:v>
                  </c:pt>
                  <c:pt idx="7">
                    <c:v>8.2467158426554873E-2</c:v>
                  </c:pt>
                  <c:pt idx="8">
                    <c:v>1.8172119917315535</c:v>
                  </c:pt>
                </c:numCache>
              </c:numRef>
            </c:plus>
            <c:minus>
              <c:numRef>
                <c:f>Sheet2!$R$27:$R$35</c:f>
                <c:numCache>
                  <c:formatCode>General</c:formatCode>
                  <c:ptCount val="9"/>
                  <c:pt idx="0">
                    <c:v>0.42799246811132874</c:v>
                  </c:pt>
                  <c:pt idx="1">
                    <c:v>0.43015342748980034</c:v>
                  </c:pt>
                  <c:pt idx="2">
                    <c:v>0.36492300059048544</c:v>
                  </c:pt>
                  <c:pt idx="3">
                    <c:v>2.2893832230181004</c:v>
                  </c:pt>
                  <c:pt idx="4">
                    <c:v>0.14892909593590151</c:v>
                  </c:pt>
                  <c:pt idx="5">
                    <c:v>2.8837860739402619E-2</c:v>
                  </c:pt>
                  <c:pt idx="6">
                    <c:v>8.2244118207885172E-2</c:v>
                  </c:pt>
                  <c:pt idx="7">
                    <c:v>8.2467158426554873E-2</c:v>
                  </c:pt>
                  <c:pt idx="8">
                    <c:v>1.8172119917315535</c:v>
                  </c:pt>
                </c:numCache>
              </c:numRef>
            </c:minus>
          </c:errBars>
          <c:cat>
            <c:strRef>
              <c:f>Sheet2!$C$27:$C$35</c:f>
              <c:strCache>
                <c:ptCount val="9"/>
                <c:pt idx="0">
                  <c:v>PRR5 (Bra009768)</c:v>
                </c:pt>
                <c:pt idx="1">
                  <c:v>PRR5 (Bra029407)</c:v>
                </c:pt>
                <c:pt idx="2">
                  <c:v>PRR5 (Bra036517)</c:v>
                </c:pt>
                <c:pt idx="3">
                  <c:v>LKP2 (Bra038832)</c:v>
                </c:pt>
                <c:pt idx="4">
                  <c:v>RVE8 (Bra029778)</c:v>
                </c:pt>
                <c:pt idx="5">
                  <c:v>LHY (Bra033291)</c:v>
                </c:pt>
                <c:pt idx="6">
                  <c:v>LHY (Bra030496)</c:v>
                </c:pt>
                <c:pt idx="7">
                  <c:v>GI (Bra024536)</c:v>
                </c:pt>
                <c:pt idx="8">
                  <c:v>COP1(Bra021818)</c:v>
                </c:pt>
              </c:strCache>
            </c:strRef>
          </c:cat>
          <c:val>
            <c:numRef>
              <c:f>Sheet2!$I$27:$I$35</c:f>
              <c:numCache>
                <c:formatCode>General</c:formatCode>
                <c:ptCount val="9"/>
                <c:pt idx="0">
                  <c:v>8.0214775735770232</c:v>
                </c:pt>
                <c:pt idx="1">
                  <c:v>7.9325992659130593</c:v>
                </c:pt>
                <c:pt idx="2">
                  <c:v>9.9947039858678828</c:v>
                </c:pt>
                <c:pt idx="3">
                  <c:v>4.1241791646094041</c:v>
                </c:pt>
                <c:pt idx="4">
                  <c:v>14.505032191983402</c:v>
                </c:pt>
                <c:pt idx="5">
                  <c:v>15.924548933808866</c:v>
                </c:pt>
                <c:pt idx="6">
                  <c:v>16.0926443493227</c:v>
                </c:pt>
                <c:pt idx="7">
                  <c:v>14.7943599902286</c:v>
                </c:pt>
                <c:pt idx="8">
                  <c:v>4.7724184480753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9E-46B4-B94E-A2524E44054E}"/>
            </c:ext>
          </c:extLst>
        </c:ser>
        <c:ser>
          <c:idx val="1"/>
          <c:order val="1"/>
          <c:tx>
            <c:strRef>
              <c:f>Sheet2!$J$26</c:f>
              <c:strCache>
                <c:ptCount val="1"/>
                <c:pt idx="0">
                  <c:v>GK1-12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S$27:$S$35</c:f>
                <c:numCache>
                  <c:formatCode>General</c:formatCode>
                  <c:ptCount val="9"/>
                  <c:pt idx="0">
                    <c:v>0.27518326265068271</c:v>
                  </c:pt>
                  <c:pt idx="1">
                    <c:v>0.19476089327966567</c:v>
                  </c:pt>
                  <c:pt idx="2">
                    <c:v>0.13678470560488853</c:v>
                  </c:pt>
                  <c:pt idx="3">
                    <c:v>4.1005142826917251E-2</c:v>
                  </c:pt>
                  <c:pt idx="4">
                    <c:v>0.16712578491744054</c:v>
                  </c:pt>
                  <c:pt idx="5">
                    <c:v>0.16537516613495798</c:v>
                  </c:pt>
                  <c:pt idx="6">
                    <c:v>9.271653831010368E-2</c:v>
                  </c:pt>
                  <c:pt idx="7">
                    <c:v>4.5454430505543264E-2</c:v>
                  </c:pt>
                  <c:pt idx="8">
                    <c:v>0</c:v>
                  </c:pt>
                </c:numCache>
              </c:numRef>
            </c:plus>
            <c:minus>
              <c:numRef>
                <c:f>Sheet2!$S$27:$S$35</c:f>
                <c:numCache>
                  <c:formatCode>General</c:formatCode>
                  <c:ptCount val="9"/>
                  <c:pt idx="0">
                    <c:v>0.27518326265068271</c:v>
                  </c:pt>
                  <c:pt idx="1">
                    <c:v>0.19476089327966567</c:v>
                  </c:pt>
                  <c:pt idx="2">
                    <c:v>0.13678470560488853</c:v>
                  </c:pt>
                  <c:pt idx="3">
                    <c:v>4.1005142826917251E-2</c:v>
                  </c:pt>
                  <c:pt idx="4">
                    <c:v>0.16712578491744054</c:v>
                  </c:pt>
                  <c:pt idx="5">
                    <c:v>0.16537516613495798</c:v>
                  </c:pt>
                  <c:pt idx="6">
                    <c:v>9.271653831010368E-2</c:v>
                  </c:pt>
                  <c:pt idx="7">
                    <c:v>4.5454430505543264E-2</c:v>
                  </c:pt>
                  <c:pt idx="8">
                    <c:v>0</c:v>
                  </c:pt>
                </c:numCache>
              </c:numRef>
            </c:minus>
          </c:errBars>
          <c:cat>
            <c:strRef>
              <c:f>Sheet2!$C$27:$C$35</c:f>
              <c:strCache>
                <c:ptCount val="9"/>
                <c:pt idx="0">
                  <c:v>PRR5 (Bra009768)</c:v>
                </c:pt>
                <c:pt idx="1">
                  <c:v>PRR5 (Bra029407)</c:v>
                </c:pt>
                <c:pt idx="2">
                  <c:v>PRR5 (Bra036517)</c:v>
                </c:pt>
                <c:pt idx="3">
                  <c:v>LKP2 (Bra038832)</c:v>
                </c:pt>
                <c:pt idx="4">
                  <c:v>RVE8 (Bra029778)</c:v>
                </c:pt>
                <c:pt idx="5">
                  <c:v>LHY (Bra033291)</c:v>
                </c:pt>
                <c:pt idx="6">
                  <c:v>LHY (Bra030496)</c:v>
                </c:pt>
                <c:pt idx="7">
                  <c:v>GI (Bra024536)</c:v>
                </c:pt>
                <c:pt idx="8">
                  <c:v>COP1(Bra021818)</c:v>
                </c:pt>
              </c:strCache>
            </c:strRef>
          </c:cat>
          <c:val>
            <c:numRef>
              <c:f>Sheet2!$J$27:$J$35</c:f>
              <c:numCache>
                <c:formatCode>General</c:formatCode>
                <c:ptCount val="9"/>
                <c:pt idx="0">
                  <c:v>10.801017841072769</c:v>
                </c:pt>
                <c:pt idx="1">
                  <c:v>9.1499358495371848</c:v>
                </c:pt>
                <c:pt idx="2">
                  <c:v>11.147513063060666</c:v>
                </c:pt>
                <c:pt idx="3">
                  <c:v>7.022819297294693</c:v>
                </c:pt>
                <c:pt idx="4">
                  <c:v>13.295334629618033</c:v>
                </c:pt>
                <c:pt idx="5">
                  <c:v>14.678429827541466</c:v>
                </c:pt>
                <c:pt idx="6">
                  <c:v>14.8399025726956</c:v>
                </c:pt>
                <c:pt idx="7">
                  <c:v>12.930173250652198</c:v>
                </c:pt>
                <c:pt idx="8">
                  <c:v>2.80240314452169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59E-46B4-B94E-A2524E4405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3852160"/>
        <c:axId val="200038016"/>
      </c:barChart>
      <c:catAx>
        <c:axId val="1338521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Circadian related genes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31591086043838978"/>
              <c:y val="0.83701370662000585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0038016"/>
        <c:crosses val="autoZero"/>
        <c:auto val="1"/>
        <c:lblAlgn val="ctr"/>
        <c:lblOffset val="100"/>
        <c:noMultiLvlLbl val="0"/>
      </c:catAx>
      <c:valAx>
        <c:axId val="200038016"/>
        <c:scaling>
          <c:orientation val="minMax"/>
          <c:max val="2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 Count (TMM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4.4682839952538467E-2"/>
              <c:y val="8.889545056867892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3852160"/>
        <c:crosses val="autoZero"/>
        <c:crossBetween val="between"/>
        <c:majorUnit val="5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21071477087118798"/>
          <c:y val="5.0542067658209393E-2"/>
          <c:w val="0.39001869900705571"/>
          <c:h val="0.1026195683872849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40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9</c:f>
              <c:strCache>
                <c:ptCount val="1"/>
                <c:pt idx="0">
                  <c:v>DH0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9:$F$10</c:f>
                <c:numCache>
                  <c:formatCode>General</c:formatCode>
                  <c:ptCount val="2"/>
                  <c:pt idx="0">
                    <c:v>122.59</c:v>
                  </c:pt>
                  <c:pt idx="1">
                    <c:v>201.47</c:v>
                  </c:pt>
                </c:numCache>
              </c:numRef>
            </c:plus>
            <c:minus>
              <c:numRef>
                <c:f>Sheet1!$F$9:$F$10</c:f>
                <c:numCache>
                  <c:formatCode>General</c:formatCode>
                  <c:ptCount val="2"/>
                  <c:pt idx="0">
                    <c:v>122.59</c:v>
                  </c:pt>
                  <c:pt idx="1">
                    <c:v>201.47</c:v>
                  </c:pt>
                </c:numCache>
              </c:numRef>
            </c:minus>
          </c:errBars>
          <c:cat>
            <c:strRef>
              <c:f>Sheet1!$B$9:$B$10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C$9:$C$10</c:f>
              <c:numCache>
                <c:formatCode>General</c:formatCode>
                <c:ptCount val="2"/>
                <c:pt idx="0">
                  <c:v>3654.838936811851</c:v>
                </c:pt>
                <c:pt idx="1">
                  <c:v>6448.7308210362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7E-4A6E-AE53-BE62773EF0C3}"/>
            </c:ext>
          </c:extLst>
        </c:ser>
        <c:ser>
          <c:idx val="1"/>
          <c:order val="1"/>
          <c:tx>
            <c:strRef>
              <c:f>Sheet1!$A$11</c:f>
              <c:strCache>
                <c:ptCount val="1"/>
                <c:pt idx="0">
                  <c:v>GK1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F$11:$F$12</c:f>
                <c:numCache>
                  <c:formatCode>General</c:formatCode>
                  <c:ptCount val="2"/>
                  <c:pt idx="0">
                    <c:v>103.85</c:v>
                  </c:pt>
                  <c:pt idx="1">
                    <c:v>204.9</c:v>
                  </c:pt>
                </c:numCache>
              </c:numRef>
            </c:plus>
            <c:minus>
              <c:numRef>
                <c:f>Sheet1!$F$11:$F$12</c:f>
                <c:numCache>
                  <c:formatCode>General</c:formatCode>
                  <c:ptCount val="2"/>
                  <c:pt idx="0">
                    <c:v>103.85</c:v>
                  </c:pt>
                  <c:pt idx="1">
                    <c:v>204.9</c:v>
                  </c:pt>
                </c:numCache>
              </c:numRef>
            </c:minus>
          </c:errBars>
          <c:cat>
            <c:strRef>
              <c:f>Sheet1!$B$9:$B$10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C$11:$C$12</c:f>
              <c:numCache>
                <c:formatCode>General</c:formatCode>
                <c:ptCount val="2"/>
                <c:pt idx="0">
                  <c:v>4401.9949492828864</c:v>
                </c:pt>
                <c:pt idx="1">
                  <c:v>6402.12916084826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7E-4A6E-AE53-BE62773EF0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894272"/>
        <c:axId val="200035136"/>
      </c:barChart>
      <c:catAx>
        <c:axId val="1638942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0035136"/>
        <c:crosses val="autoZero"/>
        <c:auto val="1"/>
        <c:lblAlgn val="ctr"/>
        <c:lblOffset val="100"/>
        <c:noMultiLvlLbl val="0"/>
      </c:catAx>
      <c:valAx>
        <c:axId val="200035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638942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8214079499773892"/>
          <c:y val="7.2366264859460058E-2"/>
          <c:w val="0.21158173348501183"/>
          <c:h val="0.27854710587712478"/>
        </c:manualLayout>
      </c:layout>
      <c:overlay val="0"/>
      <c:txPr>
        <a:bodyPr/>
        <a:lstStyle/>
        <a:p>
          <a:pPr>
            <a:defRPr sz="3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4400" b="1"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2260515654755106"/>
          <c:y val="6.0428563492945231E-2"/>
          <c:w val="0.72108390538766443"/>
          <c:h val="0.768578491278746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9</c:f>
              <c:strCache>
                <c:ptCount val="1"/>
                <c:pt idx="0">
                  <c:v>DH0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9:$G$10</c:f>
                <c:numCache>
                  <c:formatCode>General</c:formatCode>
                  <c:ptCount val="2"/>
                  <c:pt idx="0">
                    <c:v>115.07</c:v>
                  </c:pt>
                  <c:pt idx="1">
                    <c:v>26.62</c:v>
                  </c:pt>
                </c:numCache>
              </c:numRef>
            </c:plus>
            <c:minus>
              <c:numRef>
                <c:f>Sheet1!$G$9:$G$10</c:f>
                <c:numCache>
                  <c:formatCode>General</c:formatCode>
                  <c:ptCount val="2"/>
                  <c:pt idx="0">
                    <c:v>115.07</c:v>
                  </c:pt>
                  <c:pt idx="1">
                    <c:v>26.62</c:v>
                  </c:pt>
                </c:numCache>
              </c:numRef>
            </c:minus>
          </c:errBars>
          <c:cat>
            <c:strRef>
              <c:f>Sheet1!$B$9:$B$10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D$9:$D$10</c:f>
              <c:numCache>
                <c:formatCode>General</c:formatCode>
                <c:ptCount val="2"/>
                <c:pt idx="0">
                  <c:v>4933.407669194924</c:v>
                </c:pt>
                <c:pt idx="1">
                  <c:v>4535.5223883242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9C-4B19-ACBF-ECF1F7EE67C9}"/>
            </c:ext>
          </c:extLst>
        </c:ser>
        <c:ser>
          <c:idx val="1"/>
          <c:order val="1"/>
          <c:tx>
            <c:strRef>
              <c:f>Sheet1!$A$11</c:f>
              <c:strCache>
                <c:ptCount val="1"/>
                <c:pt idx="0">
                  <c:v>GK1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11:$G$12</c:f>
                <c:numCache>
                  <c:formatCode>General</c:formatCode>
                  <c:ptCount val="2"/>
                  <c:pt idx="0">
                    <c:v>85.06</c:v>
                  </c:pt>
                  <c:pt idx="1">
                    <c:v>106.77</c:v>
                  </c:pt>
                </c:numCache>
              </c:numRef>
            </c:plus>
            <c:minus>
              <c:numRef>
                <c:f>Sheet1!$G$11:$G$12</c:f>
                <c:numCache>
                  <c:formatCode>General</c:formatCode>
                  <c:ptCount val="2"/>
                  <c:pt idx="0">
                    <c:v>85.06</c:v>
                  </c:pt>
                  <c:pt idx="1">
                    <c:v>106.77</c:v>
                  </c:pt>
                </c:numCache>
              </c:numRef>
            </c:minus>
          </c:errBars>
          <c:cat>
            <c:strRef>
              <c:f>Sheet1!$B$9:$B$10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D$11:$D$12</c:f>
              <c:numCache>
                <c:formatCode>General</c:formatCode>
                <c:ptCount val="2"/>
                <c:pt idx="0">
                  <c:v>7963.8416966047516</c:v>
                </c:pt>
                <c:pt idx="1">
                  <c:v>5390.5691238967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A9C-4B19-ACBF-ECF1F7EE67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9886336"/>
        <c:axId val="200034560"/>
      </c:barChart>
      <c:catAx>
        <c:axId val="1998863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00034560"/>
        <c:crosses val="autoZero"/>
        <c:auto val="1"/>
        <c:lblAlgn val="ctr"/>
        <c:lblOffset val="100"/>
        <c:noMultiLvlLbl val="0"/>
      </c:catAx>
      <c:valAx>
        <c:axId val="2000345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9988633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0461288730047213"/>
          <c:y val="0.1015116375958227"/>
          <c:w val="0.21901782039867246"/>
          <c:h val="0.2255402177535829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4400" b="1"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093320616958054"/>
          <c:y val="6.0428563492945231E-2"/>
          <c:w val="0.67947565685189903"/>
          <c:h val="0.768578491278746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9</c:f>
              <c:strCache>
                <c:ptCount val="1"/>
                <c:pt idx="0">
                  <c:v>DH0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9:$H$10</c:f>
                <c:numCache>
                  <c:formatCode>General</c:formatCode>
                  <c:ptCount val="2"/>
                  <c:pt idx="0">
                    <c:v>15.39</c:v>
                  </c:pt>
                  <c:pt idx="1">
                    <c:v>29.09</c:v>
                  </c:pt>
                </c:numCache>
              </c:numRef>
            </c:plus>
            <c:minus>
              <c:numRef>
                <c:f>Sheet1!$H$9:$H$10</c:f>
                <c:numCache>
                  <c:formatCode>General</c:formatCode>
                  <c:ptCount val="2"/>
                  <c:pt idx="0">
                    <c:v>15.39</c:v>
                  </c:pt>
                  <c:pt idx="1">
                    <c:v>29.09</c:v>
                  </c:pt>
                </c:numCache>
              </c:numRef>
            </c:minus>
          </c:errBars>
          <c:cat>
            <c:strRef>
              <c:f>Sheet1!$B$9:$B$10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E$9:$E$10</c:f>
              <c:numCache>
                <c:formatCode>General</c:formatCode>
                <c:ptCount val="2"/>
                <c:pt idx="0">
                  <c:v>989.14879449935313</c:v>
                </c:pt>
                <c:pt idx="1">
                  <c:v>554.893955651509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55-4CF3-8235-A439F33DFA12}"/>
            </c:ext>
          </c:extLst>
        </c:ser>
        <c:ser>
          <c:idx val="1"/>
          <c:order val="1"/>
          <c:tx>
            <c:strRef>
              <c:f>Sheet1!$A$11</c:f>
              <c:strCache>
                <c:ptCount val="1"/>
                <c:pt idx="0">
                  <c:v>GK1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11:$H$12</c:f>
                <c:numCache>
                  <c:formatCode>General</c:formatCode>
                  <c:ptCount val="2"/>
                  <c:pt idx="0">
                    <c:v>31.03</c:v>
                  </c:pt>
                  <c:pt idx="1">
                    <c:v>64.040000000000006</c:v>
                  </c:pt>
                </c:numCache>
              </c:numRef>
            </c:plus>
            <c:minus>
              <c:numRef>
                <c:f>Sheet1!$H$11:$H$12</c:f>
                <c:numCache>
                  <c:formatCode>General</c:formatCode>
                  <c:ptCount val="2"/>
                  <c:pt idx="0">
                    <c:v>31.03</c:v>
                  </c:pt>
                  <c:pt idx="1">
                    <c:v>64.040000000000006</c:v>
                  </c:pt>
                </c:numCache>
              </c:numRef>
            </c:minus>
          </c:errBars>
          <c:cat>
            <c:strRef>
              <c:f>Sheet1!$B$9:$B$10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E$11:$E$12</c:f>
              <c:numCache>
                <c:formatCode>General</c:formatCode>
                <c:ptCount val="2"/>
                <c:pt idx="0">
                  <c:v>2177.4817163616535</c:v>
                </c:pt>
                <c:pt idx="1">
                  <c:v>1140.26120172223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55-4CF3-8235-A439F33DFA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894784"/>
        <c:axId val="142878400"/>
      </c:barChart>
      <c:catAx>
        <c:axId val="163894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42878400"/>
        <c:crosses val="autoZero"/>
        <c:auto val="1"/>
        <c:lblAlgn val="ctr"/>
        <c:lblOffset val="100"/>
        <c:noMultiLvlLbl val="0"/>
      </c:catAx>
      <c:valAx>
        <c:axId val="1428784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638947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50028175664362806"/>
          <c:y val="0.17029566159315632"/>
          <c:w val="0.21901782039867246"/>
          <c:h val="0.2255402177535829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4400" b="1"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352960782135319"/>
          <c:y val="5.0780305456256496E-2"/>
          <c:w val="0.81489791133602973"/>
          <c:h val="0.793282717518566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istogram-GK GSL'!$A$196</c:f>
              <c:strCache>
                <c:ptCount val="1"/>
                <c:pt idx="0">
                  <c:v>DH0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cat>
            <c:strRef>
              <c:f>'histogram-GK GSL'!$B$196:$B$197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'histogram-GK GSL'!$K$196:$K$197</c:f>
              <c:numCache>
                <c:formatCode>General</c:formatCode>
                <c:ptCount val="2"/>
                <c:pt idx="0">
                  <c:v>8.8417949948117158</c:v>
                </c:pt>
                <c:pt idx="1">
                  <c:v>7.1513221568956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494-40A7-A344-38C3235A9D6B}"/>
            </c:ext>
          </c:extLst>
        </c:ser>
        <c:ser>
          <c:idx val="1"/>
          <c:order val="1"/>
          <c:tx>
            <c:strRef>
              <c:f>'histogram-GK GSL'!$A$198</c:f>
              <c:strCache>
                <c:ptCount val="1"/>
                <c:pt idx="0">
                  <c:v>GK1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cat>
            <c:strRef>
              <c:f>'histogram-GK GSL'!$B$196:$B$197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'histogram-GK GSL'!$K$198:$K$199</c:f>
              <c:numCache>
                <c:formatCode>General</c:formatCode>
                <c:ptCount val="2"/>
                <c:pt idx="0">
                  <c:v>5.3668478421228976</c:v>
                </c:pt>
                <c:pt idx="1">
                  <c:v>3.97098958277656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494-40A7-A344-38C3235A9D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895296"/>
        <c:axId val="142880128"/>
      </c:barChart>
      <c:catAx>
        <c:axId val="163895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42880128"/>
        <c:crosses val="autoZero"/>
        <c:auto val="1"/>
        <c:lblAlgn val="ctr"/>
        <c:lblOffset val="100"/>
        <c:noMultiLvlLbl val="0"/>
      </c:catAx>
      <c:valAx>
        <c:axId val="1428801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638952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6021898697991867"/>
          <c:y val="4.9076411381641358E-2"/>
          <c:w val="0.28920980585558903"/>
          <c:h val="0.2387094542914035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4400"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161877204691122"/>
          <c:y val="7.0424271484137185E-2"/>
          <c:w val="0.61398262808242543"/>
          <c:h val="0.491647148065824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I$36</c:f>
              <c:strCache>
                <c:ptCount val="1"/>
                <c:pt idx="0">
                  <c:v>DH03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R$37:$R$40</c:f>
                <c:numCache>
                  <c:formatCode>General</c:formatCode>
                  <c:ptCount val="4"/>
                  <c:pt idx="0">
                    <c:v>0.86735985385298708</c:v>
                  </c:pt>
                  <c:pt idx="1">
                    <c:v>9.6810160667302581E-2</c:v>
                  </c:pt>
                  <c:pt idx="2">
                    <c:v>4.2600898690822758E-2</c:v>
                  </c:pt>
                  <c:pt idx="3">
                    <c:v>0.21422370657292275</c:v>
                  </c:pt>
                </c:numCache>
              </c:numRef>
            </c:plus>
            <c:minus>
              <c:numRef>
                <c:f>Sheet2!$R$37:$R$40</c:f>
                <c:numCache>
                  <c:formatCode>General</c:formatCode>
                  <c:ptCount val="4"/>
                  <c:pt idx="0">
                    <c:v>0.86735985385298708</c:v>
                  </c:pt>
                  <c:pt idx="1">
                    <c:v>9.6810160667302581E-2</c:v>
                  </c:pt>
                  <c:pt idx="2">
                    <c:v>4.2600898690822758E-2</c:v>
                  </c:pt>
                  <c:pt idx="3">
                    <c:v>0.21422370657292275</c:v>
                  </c:pt>
                </c:numCache>
              </c:numRef>
            </c:minus>
          </c:errBars>
          <c:cat>
            <c:strRef>
              <c:f>Sheet2!$C$37:$C$40</c:f>
              <c:strCache>
                <c:ptCount val="4"/>
                <c:pt idx="0">
                  <c:v>IAA19 (Bra001598)</c:v>
                </c:pt>
                <c:pt idx="1">
                  <c:v>UVR8 (Bra029198)</c:v>
                </c:pt>
                <c:pt idx="2">
                  <c:v>HYH (Bra022225)</c:v>
                </c:pt>
                <c:pt idx="3">
                  <c:v>PIF8 (Bra037312)</c:v>
                </c:pt>
              </c:strCache>
            </c:strRef>
          </c:cat>
          <c:val>
            <c:numRef>
              <c:f>Sheet2!$I$37:$I$40</c:f>
              <c:numCache>
                <c:formatCode>General</c:formatCode>
                <c:ptCount val="4"/>
                <c:pt idx="0">
                  <c:v>5.9432558339733959</c:v>
                </c:pt>
                <c:pt idx="1">
                  <c:v>10.994003844929201</c:v>
                </c:pt>
                <c:pt idx="2">
                  <c:v>11.399189062960966</c:v>
                </c:pt>
                <c:pt idx="3">
                  <c:v>9.64713781440784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DA-45BD-ACB8-E2D1E0B9A296}"/>
            </c:ext>
          </c:extLst>
        </c:ser>
        <c:ser>
          <c:idx val="1"/>
          <c:order val="1"/>
          <c:tx>
            <c:strRef>
              <c:f>Sheet2!$J$36</c:f>
              <c:strCache>
                <c:ptCount val="1"/>
                <c:pt idx="0">
                  <c:v>GK1-12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S$37:$S$40</c:f>
                <c:numCache>
                  <c:formatCode>General</c:formatCode>
                  <c:ptCount val="4"/>
                  <c:pt idx="0">
                    <c:v>0.54892305659464125</c:v>
                  </c:pt>
                  <c:pt idx="1">
                    <c:v>4.43554546067235E-2</c:v>
                  </c:pt>
                  <c:pt idx="2">
                    <c:v>3.3029930026576115E-2</c:v>
                  </c:pt>
                  <c:pt idx="3">
                    <c:v>0.2794536596138954</c:v>
                  </c:pt>
                </c:numCache>
              </c:numRef>
            </c:plus>
            <c:minus>
              <c:numRef>
                <c:f>Sheet2!$S$37:$S$40</c:f>
                <c:numCache>
                  <c:formatCode>General</c:formatCode>
                  <c:ptCount val="4"/>
                  <c:pt idx="0">
                    <c:v>0.54892305659464125</c:v>
                  </c:pt>
                  <c:pt idx="1">
                    <c:v>4.43554546067235E-2</c:v>
                  </c:pt>
                  <c:pt idx="2">
                    <c:v>3.3029930026576115E-2</c:v>
                  </c:pt>
                  <c:pt idx="3">
                    <c:v>0.2794536596138954</c:v>
                  </c:pt>
                </c:numCache>
              </c:numRef>
            </c:minus>
          </c:errBars>
          <c:cat>
            <c:strRef>
              <c:f>Sheet2!$C$37:$C$40</c:f>
              <c:strCache>
                <c:ptCount val="4"/>
                <c:pt idx="0">
                  <c:v>IAA19 (Bra001598)</c:v>
                </c:pt>
                <c:pt idx="1">
                  <c:v>UVR8 (Bra029198)</c:v>
                </c:pt>
                <c:pt idx="2">
                  <c:v>HYH (Bra022225)</c:v>
                </c:pt>
                <c:pt idx="3">
                  <c:v>PIF8 (Bra037312)</c:v>
                </c:pt>
              </c:strCache>
            </c:strRef>
          </c:cat>
          <c:val>
            <c:numRef>
              <c:f>Sheet2!$J$37:$J$40</c:f>
              <c:numCache>
                <c:formatCode>General</c:formatCode>
                <c:ptCount val="4"/>
                <c:pt idx="0">
                  <c:v>9.2873939761178406</c:v>
                </c:pt>
                <c:pt idx="1">
                  <c:v>12.677150762896298</c:v>
                </c:pt>
                <c:pt idx="2">
                  <c:v>10.392939875786134</c:v>
                </c:pt>
                <c:pt idx="3">
                  <c:v>8.49199402644036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DA-45BD-ACB8-E2D1E0B9A2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616512"/>
        <c:axId val="200039168"/>
      </c:barChart>
      <c:catAx>
        <c:axId val="1356165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Light signaling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0.34146058972592891"/>
              <c:y val="0.86441788687858434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0039168"/>
        <c:crosses val="autoZero"/>
        <c:auto val="1"/>
        <c:lblAlgn val="ctr"/>
        <c:lblOffset val="100"/>
        <c:noMultiLvlLbl val="0"/>
      </c:catAx>
      <c:valAx>
        <c:axId val="200039168"/>
        <c:scaling>
          <c:orientation val="minMax"/>
          <c:max val="16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ead Count (TMM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3.5534738817515531E-2"/>
              <c:y val="8.51859302715159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35616512"/>
        <c:crosses val="autoZero"/>
        <c:crossBetween val="between"/>
        <c:majorUnit val="4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31776591464926029"/>
          <c:y val="7.8292719265672051E-2"/>
          <c:w val="0.59099396507280466"/>
          <c:h val="8.5499442015797969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40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6940171784438991"/>
          <c:y val="0.11720803155972806"/>
          <c:w val="0.56383667188907372"/>
          <c:h val="0.578773810498947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6F9-4977-9EEC-759F895CED6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6F9-4977-9EEC-759F895CED69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6F9-4977-9EEC-759F895CED69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6F9-4977-9EEC-759F895CED69}"/>
              </c:ext>
            </c:extLst>
          </c:dPt>
          <c:errBars>
            <c:errBarType val="plus"/>
            <c:errValType val="cust"/>
            <c:noEndCap val="0"/>
            <c:plus>
              <c:numRef>
                <c:f>'Bra001598'!$Q$4:$Q$7</c:f>
                <c:numCache>
                  <c:formatCode>General</c:formatCode>
                  <c:ptCount val="4"/>
                  <c:pt idx="0">
                    <c:v>3.7113375197138415E-5</c:v>
                  </c:pt>
                  <c:pt idx="1">
                    <c:v>5.2897786801289938E-5</c:v>
                  </c:pt>
                  <c:pt idx="2">
                    <c:v>1.3866585315517094E-4</c:v>
                  </c:pt>
                  <c:pt idx="3">
                    <c:v>2.9765883403852722E-5</c:v>
                  </c:pt>
                </c:numCache>
              </c:numRef>
            </c:plus>
            <c:minus>
              <c:numRef>
                <c:f>'Bra001598'!$Q$4:$Q$7</c:f>
                <c:numCache>
                  <c:formatCode>General</c:formatCode>
                  <c:ptCount val="4"/>
                  <c:pt idx="0">
                    <c:v>3.7113375197138415E-5</c:v>
                  </c:pt>
                  <c:pt idx="1">
                    <c:v>5.2897786801289938E-5</c:v>
                  </c:pt>
                  <c:pt idx="2">
                    <c:v>1.3866585315517094E-4</c:v>
                  </c:pt>
                  <c:pt idx="3">
                    <c:v>2.9765883403852722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ra001598'!$L$4:$L$7</c:f>
              <c:strCache>
                <c:ptCount val="4"/>
                <c:pt idx="0">
                  <c:v>DH03_AM</c:v>
                </c:pt>
                <c:pt idx="1">
                  <c:v>DH03_PM</c:v>
                </c:pt>
                <c:pt idx="2">
                  <c:v>GK1-12_AM</c:v>
                </c:pt>
                <c:pt idx="3">
                  <c:v>GK1-12_PM</c:v>
                </c:pt>
              </c:strCache>
            </c:strRef>
          </c:cat>
          <c:val>
            <c:numRef>
              <c:f>'Bra001598'!$P$4:$P$7</c:f>
              <c:numCache>
                <c:formatCode>General</c:formatCode>
                <c:ptCount val="4"/>
                <c:pt idx="0">
                  <c:v>3.4346615207922352E-4</c:v>
                </c:pt>
                <c:pt idx="1">
                  <c:v>7.4652787347721284E-4</c:v>
                </c:pt>
                <c:pt idx="2">
                  <c:v>7.2474046059110874E-4</c:v>
                </c:pt>
                <c:pt idx="3">
                  <c:v>6.6132335944958686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6F9-4977-9EEC-759F895CED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850112"/>
        <c:axId val="142656640"/>
      </c:barChart>
      <c:catAx>
        <c:axId val="133850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2656640"/>
        <c:crosses val="autoZero"/>
        <c:auto val="1"/>
        <c:lblAlgn val="ctr"/>
        <c:lblOffset val="100"/>
        <c:noMultiLvlLbl val="0"/>
      </c:catAx>
      <c:valAx>
        <c:axId val="142656640"/>
        <c:scaling>
          <c:orientation val="minMax"/>
          <c:max val="1.2000000000000003E-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</a:t>
                </a:r>
                <a:r>
                  <a:rPr lang="en-US"/>
                  <a:t>Ct of IAA19 (Bra001598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4.9227699277316364E-2"/>
              <c:y val="0.1102350214173186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3850112"/>
        <c:crosses val="autoZero"/>
        <c:crossBetween val="between"/>
        <c:majorUnit val="4.0000000000000013E-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3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545108087381859"/>
          <c:y val="5.8526368334444419E-2"/>
          <c:w val="0.63045764733953713"/>
          <c:h val="0.5829104192980617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99C-42E2-8A5B-C06FAEDBC09A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99C-42E2-8A5B-C06FAEDBC09A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O$9:$O$12</c:f>
                <c:numCache>
                  <c:formatCode>General</c:formatCode>
                  <c:ptCount val="4"/>
                  <c:pt idx="0">
                    <c:v>5.9999999999999995E-4</c:v>
                  </c:pt>
                  <c:pt idx="1">
                    <c:v>5.0000000000000001E-3</c:v>
                  </c:pt>
                  <c:pt idx="2">
                    <c:v>8.0000000000000007E-5</c:v>
                  </c:pt>
                  <c:pt idx="3">
                    <c:v>4.0000000000000001E-3</c:v>
                  </c:pt>
                </c:numCache>
              </c:numRef>
            </c:plus>
            <c:minus>
              <c:numRef>
                <c:f>Sheet1!$O$9:$O$12</c:f>
                <c:numCache>
                  <c:formatCode>General</c:formatCode>
                  <c:ptCount val="4"/>
                  <c:pt idx="0">
                    <c:v>5.9999999999999995E-4</c:v>
                  </c:pt>
                  <c:pt idx="1">
                    <c:v>5.0000000000000001E-3</c:v>
                  </c:pt>
                  <c:pt idx="2">
                    <c:v>8.0000000000000007E-5</c:v>
                  </c:pt>
                  <c:pt idx="3">
                    <c:v>4.000000000000000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9:$G$12</c:f>
              <c:strCache>
                <c:ptCount val="4"/>
                <c:pt idx="0">
                  <c:v>DH03_AM</c:v>
                </c:pt>
                <c:pt idx="1">
                  <c:v>DH03_PM</c:v>
                </c:pt>
                <c:pt idx="2">
                  <c:v>GK1-12_AM</c:v>
                </c:pt>
                <c:pt idx="3">
                  <c:v>GK1-12_PM</c:v>
                </c:pt>
              </c:strCache>
            </c:strRef>
          </c:cat>
          <c:val>
            <c:numRef>
              <c:f>Sheet1!$N$9:$N$12</c:f>
              <c:numCache>
                <c:formatCode>General</c:formatCode>
                <c:ptCount val="4"/>
                <c:pt idx="0">
                  <c:v>2.8927686568097025E-3</c:v>
                </c:pt>
                <c:pt idx="1">
                  <c:v>3.0046345390082885E-2</c:v>
                </c:pt>
                <c:pt idx="2">
                  <c:v>6.209077960868171E-4</c:v>
                </c:pt>
                <c:pt idx="3">
                  <c:v>1.62134321743710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99C-42E2-8A5B-C06FAEDBC0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614464"/>
        <c:axId val="142658368"/>
      </c:barChart>
      <c:catAx>
        <c:axId val="135614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2658368"/>
        <c:crosses val="autoZero"/>
        <c:auto val="1"/>
        <c:lblAlgn val="ctr"/>
        <c:lblOffset val="100"/>
        <c:noMultiLvlLbl val="0"/>
      </c:catAx>
      <c:valAx>
        <c:axId val="14265836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</a:t>
                </a:r>
                <a:r>
                  <a:rPr lang="en-US"/>
                  <a:t>Ct of PRR5 (Bra0009768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1.3247310769358315E-2"/>
              <c:y val="5.5832215947091535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5614464"/>
        <c:crosses val="autoZero"/>
        <c:crossBetween val="between"/>
        <c:majorUnit val="1.0000000000000002E-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3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98597715024584"/>
          <c:y val="6.201549011103747E-2"/>
          <c:w val="0.57598592943724902"/>
          <c:h val="0.585199893966671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70-4693-AC0B-EB719476D231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70-4693-AC0B-EB719476D231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O$15:$O$18</c:f>
                <c:numCache>
                  <c:formatCode>General</c:formatCode>
                  <c:ptCount val="4"/>
                  <c:pt idx="0">
                    <c:v>0.01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1</c:v>
                  </c:pt>
                </c:numCache>
              </c:numRef>
            </c:plus>
            <c:minus>
              <c:numRef>
                <c:f>Sheet1!$O$15:$O$18</c:f>
                <c:numCache>
                  <c:formatCode>General</c:formatCode>
                  <c:ptCount val="4"/>
                  <c:pt idx="0">
                    <c:v>0.01</c:v>
                  </c:pt>
                  <c:pt idx="1">
                    <c:v>0.03</c:v>
                  </c:pt>
                  <c:pt idx="2">
                    <c:v>0.02</c:v>
                  </c:pt>
                  <c:pt idx="3">
                    <c:v>0.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15:$G$18</c:f>
              <c:strCache>
                <c:ptCount val="4"/>
                <c:pt idx="0">
                  <c:v>DH03_AM</c:v>
                </c:pt>
                <c:pt idx="1">
                  <c:v>DH03_PM</c:v>
                </c:pt>
                <c:pt idx="2">
                  <c:v>GK1-12_AM</c:v>
                </c:pt>
                <c:pt idx="3">
                  <c:v>GK1-12_PM</c:v>
                </c:pt>
              </c:strCache>
            </c:strRef>
          </c:cat>
          <c:val>
            <c:numRef>
              <c:f>Sheet1!$N$15:$N$18</c:f>
              <c:numCache>
                <c:formatCode>General</c:formatCode>
                <c:ptCount val="4"/>
                <c:pt idx="0">
                  <c:v>0.37980566605890026</c:v>
                </c:pt>
                <c:pt idx="1">
                  <c:v>0.50464240060593779</c:v>
                </c:pt>
                <c:pt idx="2">
                  <c:v>0.527289314758007</c:v>
                </c:pt>
                <c:pt idx="3">
                  <c:v>0.441351498145328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170-4693-AC0B-EB719476D2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948864"/>
        <c:axId val="142660096"/>
      </c:barChart>
      <c:catAx>
        <c:axId val="1429488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2660096"/>
        <c:crosses val="autoZero"/>
        <c:auto val="1"/>
        <c:lblAlgn val="ctr"/>
        <c:lblOffset val="100"/>
        <c:noMultiLvlLbl val="0"/>
      </c:catAx>
      <c:valAx>
        <c:axId val="142660096"/>
        <c:scaling>
          <c:orientation val="minMax"/>
          <c:max val="0.8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</a:t>
                </a:r>
                <a:r>
                  <a:rPr lang="en-US"/>
                  <a:t>Ct of PRR5 (Bra029407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7.72282565909541E-2"/>
              <c:y val="8.295210665348296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2948864"/>
        <c:crosses val="autoZero"/>
        <c:crossBetween val="between"/>
        <c:majorUnit val="0.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3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958668523835241"/>
          <c:y val="6.2544406752646942E-2"/>
          <c:w val="0.60713128780112269"/>
          <c:h val="0.6125649385200305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42B-49F0-91F7-1C65914855F0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42B-49F0-91F7-1C65914855F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O$21:$O$24</c:f>
                <c:numCache>
                  <c:formatCode>General</c:formatCode>
                  <c:ptCount val="4"/>
                  <c:pt idx="0">
                    <c:v>0.03</c:v>
                  </c:pt>
                  <c:pt idx="1">
                    <c:v>0.02</c:v>
                  </c:pt>
                  <c:pt idx="2">
                    <c:v>0.1</c:v>
                  </c:pt>
                  <c:pt idx="3">
                    <c:v>0.02</c:v>
                  </c:pt>
                </c:numCache>
              </c:numRef>
            </c:plus>
            <c:minus>
              <c:numRef>
                <c:f>Sheet1!$O$21:$O$24</c:f>
                <c:numCache>
                  <c:formatCode>General</c:formatCode>
                  <c:ptCount val="4"/>
                  <c:pt idx="0">
                    <c:v>0.03</c:v>
                  </c:pt>
                  <c:pt idx="1">
                    <c:v>0.02</c:v>
                  </c:pt>
                  <c:pt idx="2">
                    <c:v>0.1</c:v>
                  </c:pt>
                  <c:pt idx="3">
                    <c:v>0.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G$21:$G$24</c:f>
              <c:strCache>
                <c:ptCount val="4"/>
                <c:pt idx="0">
                  <c:v>DH03_AM</c:v>
                </c:pt>
                <c:pt idx="1">
                  <c:v>DH03_PM</c:v>
                </c:pt>
                <c:pt idx="2">
                  <c:v>GK1-12_AM</c:v>
                </c:pt>
                <c:pt idx="3">
                  <c:v>GK1-12_PM</c:v>
                </c:pt>
              </c:strCache>
            </c:strRef>
          </c:cat>
          <c:val>
            <c:numRef>
              <c:f>Sheet1!$N$21:$N$24</c:f>
              <c:numCache>
                <c:formatCode>General</c:formatCode>
                <c:ptCount val="4"/>
                <c:pt idx="0">
                  <c:v>0.65975395538644488</c:v>
                </c:pt>
                <c:pt idx="1">
                  <c:v>0.1235642525441118</c:v>
                </c:pt>
                <c:pt idx="2">
                  <c:v>1.1070087815953069</c:v>
                </c:pt>
                <c:pt idx="3">
                  <c:v>0.10176640845071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42B-49F0-91F7-1C65914855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726400"/>
        <c:axId val="142661824"/>
      </c:barChart>
      <c:catAx>
        <c:axId val="162726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42661824"/>
        <c:crosses val="autoZero"/>
        <c:auto val="1"/>
        <c:lblAlgn val="ctr"/>
        <c:lblOffset val="100"/>
        <c:noMultiLvlLbl val="0"/>
      </c:catAx>
      <c:valAx>
        <c:axId val="142661824"/>
        <c:scaling>
          <c:orientation val="minMax"/>
          <c:max val="1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</a:t>
                </a:r>
                <a:r>
                  <a:rPr lang="en-US"/>
                  <a:t>Ct of PRR5 (Bra036517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8.0667802367695284E-3"/>
              <c:y val="0.1037320478318544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2726400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3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0824941221660168"/>
          <c:y val="5.6781619496296565E-2"/>
          <c:w val="0.60128677324725943"/>
          <c:h val="0.551739074227729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D34-4EF0-B4BA-30E7953C617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D34-4EF0-B4BA-30E7953C6175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D34-4EF0-B4BA-30E7953C6175}"/>
              </c:ext>
            </c:extLst>
          </c:dPt>
          <c:dPt>
            <c:idx val="3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D34-4EF0-B4BA-30E7953C6175}"/>
              </c:ext>
            </c:extLst>
          </c:dPt>
          <c:errBars>
            <c:errBarType val="plus"/>
            <c:errValType val="cust"/>
            <c:noEndCap val="0"/>
            <c:plus>
              <c:numRef>
                <c:f>'qRT 평균'!$S$4:$S$7</c:f>
                <c:numCache>
                  <c:formatCode>General</c:formatCode>
                  <c:ptCount val="4"/>
                  <c:pt idx="0">
                    <c:v>1.3906978052197535E-2</c:v>
                  </c:pt>
                  <c:pt idx="1">
                    <c:v>2.8077368544084401E-2</c:v>
                  </c:pt>
                  <c:pt idx="2">
                    <c:v>1.0449946243119771E-2</c:v>
                  </c:pt>
                  <c:pt idx="3">
                    <c:v>2.7693272010041819E-2</c:v>
                  </c:pt>
                </c:numCache>
              </c:numRef>
            </c:plus>
            <c:minus>
              <c:numRef>
                <c:f>'qRT 평균'!$S$4:$S$7</c:f>
                <c:numCache>
                  <c:formatCode>General</c:formatCode>
                  <c:ptCount val="4"/>
                  <c:pt idx="0">
                    <c:v>1.3906978052197535E-2</c:v>
                  </c:pt>
                  <c:pt idx="1">
                    <c:v>2.8077368544084401E-2</c:v>
                  </c:pt>
                  <c:pt idx="2">
                    <c:v>1.0449946243119771E-2</c:v>
                  </c:pt>
                  <c:pt idx="3">
                    <c:v>2.76932720100418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qRT 평균'!$Q$4:$Q$7</c:f>
              <c:strCache>
                <c:ptCount val="4"/>
                <c:pt idx="0">
                  <c:v>DH03_AM</c:v>
                </c:pt>
                <c:pt idx="1">
                  <c:v>DH03_PM</c:v>
                </c:pt>
                <c:pt idx="2">
                  <c:v>GK1-12_AM</c:v>
                </c:pt>
                <c:pt idx="3">
                  <c:v>GK1-12_PM</c:v>
                </c:pt>
              </c:strCache>
            </c:strRef>
          </c:cat>
          <c:val>
            <c:numRef>
              <c:f>'qRT 평균'!$R$4:$R$7</c:f>
              <c:numCache>
                <c:formatCode>General</c:formatCode>
                <c:ptCount val="4"/>
                <c:pt idx="0">
                  <c:v>4.6764017135287848E-2</c:v>
                </c:pt>
                <c:pt idx="1">
                  <c:v>0.1290638503488882</c:v>
                </c:pt>
                <c:pt idx="2">
                  <c:v>2.7786885270074835E-2</c:v>
                </c:pt>
                <c:pt idx="3">
                  <c:v>9.183005957371814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D34-4EF0-B4BA-30E7953C61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5617024"/>
        <c:axId val="162817152"/>
      </c:barChart>
      <c:catAx>
        <c:axId val="135617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2817152"/>
        <c:crosses val="autoZero"/>
        <c:auto val="1"/>
        <c:lblAlgn val="ctr"/>
        <c:lblOffset val="100"/>
        <c:noMultiLvlLbl val="0"/>
      </c:catAx>
      <c:valAx>
        <c:axId val="162817152"/>
        <c:scaling>
          <c:orientation val="minMax"/>
          <c:max val="0.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Δ</a:t>
                </a:r>
                <a:r>
                  <a:rPr lang="en-US"/>
                  <a:t>Ct of GI (Bra024536)</a:t>
                </a:r>
                <a:endParaRPr lang="ko-KR"/>
              </a:p>
            </c:rich>
          </c:tx>
          <c:layout>
            <c:manualLayout>
              <c:xMode val="edge"/>
              <c:yMode val="edge"/>
              <c:x val="5.2201980651936201E-3"/>
              <c:y val="0.1238785545167103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35617024"/>
        <c:crosses val="autoZero"/>
        <c:crossBetween val="between"/>
        <c:majorUnit val="5.000000000000001E-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3200" b="0">
          <a:solidFill>
            <a:schemeClr val="tx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3359846591119504"/>
          <c:y val="7.6271058051127591E-2"/>
          <c:w val="0.61285358725573702"/>
          <c:h val="0.731423320054011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DH0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2:$G$3</c:f>
                <c:numCache>
                  <c:formatCode>General</c:formatCode>
                  <c:ptCount val="2"/>
                  <c:pt idx="0">
                    <c:v>75.961974917279065</c:v>
                  </c:pt>
                  <c:pt idx="1">
                    <c:v>27.44723179727481</c:v>
                  </c:pt>
                </c:numCache>
              </c:numRef>
            </c:plus>
            <c:minus>
              <c:numRef>
                <c:f>Sheet1!$G$2:$G$3</c:f>
                <c:numCache>
                  <c:formatCode>General</c:formatCode>
                  <c:ptCount val="2"/>
                  <c:pt idx="0">
                    <c:v>75.961974917279065</c:v>
                  </c:pt>
                  <c:pt idx="1">
                    <c:v>27.44723179727481</c:v>
                  </c:pt>
                </c:numCache>
              </c:numRef>
            </c:minus>
          </c:errBars>
          <c:cat>
            <c:strRef>
              <c:f>Sheet1!$B$2:$B$3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4609.5288095550595</c:v>
                </c:pt>
                <c:pt idx="1">
                  <c:v>4675.45169544069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DB-46A0-8A18-4DBDD0DE86E5}"/>
            </c:ext>
          </c:extLst>
        </c:ser>
        <c:ser>
          <c:idx val="1"/>
          <c:order val="1"/>
          <c:tx>
            <c:strRef>
              <c:f>Sheet1!$A$4</c:f>
              <c:strCache>
                <c:ptCount val="1"/>
                <c:pt idx="0">
                  <c:v>GK1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4:$G$5</c:f>
                <c:numCache>
                  <c:formatCode>General</c:formatCode>
                  <c:ptCount val="2"/>
                  <c:pt idx="0">
                    <c:v>22.649451060309019</c:v>
                  </c:pt>
                  <c:pt idx="1">
                    <c:v>3.5045161339810287</c:v>
                  </c:pt>
                </c:numCache>
              </c:numRef>
            </c:plus>
            <c:minus>
              <c:numRef>
                <c:f>Sheet1!$G$4:$G$5</c:f>
                <c:numCache>
                  <c:formatCode>General</c:formatCode>
                  <c:ptCount val="2"/>
                  <c:pt idx="0">
                    <c:v>22.649451060309019</c:v>
                  </c:pt>
                  <c:pt idx="1">
                    <c:v>3.5045161339810287</c:v>
                  </c:pt>
                </c:numCache>
              </c:numRef>
            </c:minus>
          </c:errBars>
          <c:cat>
            <c:strRef>
              <c:f>Sheet1!$B$2:$B$3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C$4:$C$5</c:f>
              <c:numCache>
                <c:formatCode>General</c:formatCode>
                <c:ptCount val="2"/>
                <c:pt idx="0">
                  <c:v>3980.9055906897324</c:v>
                </c:pt>
                <c:pt idx="1">
                  <c:v>3783.66074867808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DB-46A0-8A18-4DBDD0DE86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893248"/>
        <c:axId val="162820608"/>
      </c:barChart>
      <c:catAx>
        <c:axId val="1638932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62820608"/>
        <c:crosses val="autoZero"/>
        <c:auto val="1"/>
        <c:lblAlgn val="ctr"/>
        <c:lblOffset val="100"/>
        <c:noMultiLvlLbl val="0"/>
      </c:catAx>
      <c:valAx>
        <c:axId val="1628206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638932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1849026730924399"/>
          <c:y val="1.2616704663443718E-2"/>
          <c:w val="0.20894244775271884"/>
          <c:h val="0.19247359251118631"/>
        </c:manualLayout>
      </c:layout>
      <c:overlay val="0"/>
      <c:txPr>
        <a:bodyPr/>
        <a:lstStyle/>
        <a:p>
          <a:pPr>
            <a:defRPr sz="3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4400" b="1"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951341826216841"/>
          <c:y val="6.5683221187983948E-2"/>
          <c:w val="0.625542043197157"/>
          <c:h val="0.758040169449771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DH03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2:$H$3</c:f>
                <c:numCache>
                  <c:formatCode>General</c:formatCode>
                  <c:ptCount val="2"/>
                  <c:pt idx="0">
                    <c:v>21.823840175367852</c:v>
                  </c:pt>
                  <c:pt idx="1">
                    <c:v>24.023544700980331</c:v>
                  </c:pt>
                </c:numCache>
              </c:numRef>
            </c:plus>
            <c:minus>
              <c:numRef>
                <c:f>Sheet1!$H$2:$H$3</c:f>
                <c:numCache>
                  <c:formatCode>General</c:formatCode>
                  <c:ptCount val="2"/>
                  <c:pt idx="0">
                    <c:v>21.823840175367852</c:v>
                  </c:pt>
                  <c:pt idx="1">
                    <c:v>24.023544700980331</c:v>
                  </c:pt>
                </c:numCache>
              </c:numRef>
            </c:minus>
          </c:errBars>
          <c:cat>
            <c:strRef>
              <c:f>Sheet1!$B$2:$B$3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D$2:$D$3</c:f>
              <c:numCache>
                <c:formatCode>General</c:formatCode>
                <c:ptCount val="2"/>
                <c:pt idx="0">
                  <c:v>10252.08333333333</c:v>
                </c:pt>
                <c:pt idx="1">
                  <c:v>10306.24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08-4EE8-A795-8BF0F9FF5195}"/>
            </c:ext>
          </c:extLst>
        </c:ser>
        <c:ser>
          <c:idx val="1"/>
          <c:order val="1"/>
          <c:tx>
            <c:strRef>
              <c:f>Sheet1!$A$4</c:f>
              <c:strCache>
                <c:ptCount val="1"/>
                <c:pt idx="0">
                  <c:v>GK1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H$4:$H$5</c:f>
                <c:numCache>
                  <c:formatCode>General</c:formatCode>
                  <c:ptCount val="2"/>
                  <c:pt idx="0">
                    <c:v>18.071063425635288</c:v>
                  </c:pt>
                  <c:pt idx="1">
                    <c:v>44.352047679147049</c:v>
                  </c:pt>
                </c:numCache>
              </c:numRef>
            </c:plus>
            <c:minus>
              <c:numRef>
                <c:f>Sheet1!$H$4:$H$5</c:f>
                <c:numCache>
                  <c:formatCode>General</c:formatCode>
                  <c:ptCount val="2"/>
                  <c:pt idx="0">
                    <c:v>18.071063425635288</c:v>
                  </c:pt>
                  <c:pt idx="1">
                    <c:v>44.352047679147049</c:v>
                  </c:pt>
                </c:numCache>
              </c:numRef>
            </c:minus>
          </c:errBars>
          <c:cat>
            <c:strRef>
              <c:f>Sheet1!$B$2:$B$3</c:f>
              <c:strCache>
                <c:ptCount val="2"/>
                <c:pt idx="0">
                  <c:v>AM</c:v>
                </c:pt>
                <c:pt idx="1">
                  <c:v>PM</c:v>
                </c:pt>
              </c:strCache>
            </c:strRef>
          </c:cat>
          <c:val>
            <c:numRef>
              <c:f>Sheet1!$D$4:$D$5</c:f>
              <c:numCache>
                <c:formatCode>General</c:formatCode>
                <c:ptCount val="2"/>
                <c:pt idx="0">
                  <c:v>10528.124999999998</c:v>
                </c:pt>
                <c:pt idx="1">
                  <c:v>9653.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208-4EE8-A795-8BF0F9FF51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3893760"/>
        <c:axId val="162822336"/>
      </c:barChart>
      <c:catAx>
        <c:axId val="163893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62822336"/>
        <c:crosses val="autoZero"/>
        <c:auto val="1"/>
        <c:lblAlgn val="ctr"/>
        <c:lblOffset val="100"/>
        <c:noMultiLvlLbl val="0"/>
      </c:catAx>
      <c:valAx>
        <c:axId val="1628223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6389376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0311541387376709"/>
          <c:y val="1.6805197973172076E-3"/>
          <c:w val="0.21597590622646867"/>
          <c:h val="0.24515241060172058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4400" b="1"/>
      </a:pPr>
      <a:endParaRPr lang="en-US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76ABBA-118C-42ED-8BB6-D3EC80C2ACFE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E49CF7-03C5-4BD9-8820-DA71419708D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6379958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3240405" y="10066265"/>
            <a:ext cx="36724590" cy="6945868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6480810" y="18362295"/>
            <a:ext cx="30243780" cy="828103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1584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3169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4753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8633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07923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29507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1092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72677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11950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71345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48008505" y="6128275"/>
            <a:ext cx="45928244" cy="13064382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0208783" y="6128275"/>
            <a:ext cx="137079632" cy="13064382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75771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180258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12929" y="20822605"/>
            <a:ext cx="36724590" cy="6435804"/>
          </a:xfrm>
        </p:spPr>
        <p:txBody>
          <a:bodyPr anchor="t"/>
          <a:lstStyle>
            <a:lvl1pPr algn="l">
              <a:defRPr sz="191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12929" y="13734221"/>
            <a:ext cx="36724590" cy="7088384"/>
          </a:xfrm>
        </p:spPr>
        <p:txBody>
          <a:bodyPr anchor="b"/>
          <a:lstStyle>
            <a:lvl1pPr marL="0" indent="0">
              <a:buNone/>
              <a:defRPr sz="9500">
                <a:solidFill>
                  <a:schemeClr val="tx1">
                    <a:tint val="75000"/>
                  </a:schemeClr>
                </a:solidFill>
              </a:defRPr>
            </a:lvl1pPr>
            <a:lvl2pPr marL="2158461" indent="0">
              <a:buNone/>
              <a:defRPr sz="8300">
                <a:solidFill>
                  <a:schemeClr val="tx1">
                    <a:tint val="75000"/>
                  </a:schemeClr>
                </a:solidFill>
              </a:defRPr>
            </a:lvl2pPr>
            <a:lvl3pPr marL="4316934" indent="0">
              <a:buNone/>
              <a:defRPr sz="7500">
                <a:solidFill>
                  <a:schemeClr val="tx1">
                    <a:tint val="75000"/>
                  </a:schemeClr>
                </a:solidFill>
              </a:defRPr>
            </a:lvl3pPr>
            <a:lvl4pPr marL="6475396" indent="0">
              <a:buNone/>
              <a:defRPr sz="6700">
                <a:solidFill>
                  <a:schemeClr val="tx1">
                    <a:tint val="75000"/>
                  </a:schemeClr>
                </a:solidFill>
              </a:defRPr>
            </a:lvl4pPr>
            <a:lvl5pPr marL="8633861" indent="0">
              <a:buNone/>
              <a:defRPr sz="6700">
                <a:solidFill>
                  <a:schemeClr val="tx1">
                    <a:tint val="75000"/>
                  </a:schemeClr>
                </a:solidFill>
              </a:defRPr>
            </a:lvl5pPr>
            <a:lvl6pPr marL="10792330" indent="0">
              <a:buNone/>
              <a:defRPr sz="6700">
                <a:solidFill>
                  <a:schemeClr val="tx1">
                    <a:tint val="75000"/>
                  </a:schemeClr>
                </a:solidFill>
              </a:defRPr>
            </a:lvl6pPr>
            <a:lvl7pPr marL="12950791" indent="0">
              <a:buNone/>
              <a:defRPr sz="6700">
                <a:solidFill>
                  <a:schemeClr val="tx1">
                    <a:tint val="75000"/>
                  </a:schemeClr>
                </a:solidFill>
              </a:defRPr>
            </a:lvl7pPr>
            <a:lvl8pPr marL="15109257" indent="0">
              <a:buNone/>
              <a:defRPr sz="6700">
                <a:solidFill>
                  <a:schemeClr val="tx1">
                    <a:tint val="75000"/>
                  </a:schemeClr>
                </a:solidFill>
              </a:defRPr>
            </a:lvl8pPr>
            <a:lvl9pPr marL="17267722" indent="0">
              <a:buNone/>
              <a:defRPr sz="6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33806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0208778" y="35726968"/>
            <a:ext cx="91503934" cy="101045127"/>
          </a:xfrm>
        </p:spPr>
        <p:txBody>
          <a:bodyPr/>
          <a:lstStyle>
            <a:lvl1pPr>
              <a:defRPr sz="13100"/>
            </a:lvl1pPr>
            <a:lvl2pPr>
              <a:defRPr sz="11100"/>
            </a:lvl2pPr>
            <a:lvl3pPr>
              <a:defRPr sz="9500"/>
            </a:lvl3pPr>
            <a:lvl4pPr>
              <a:defRPr sz="8300"/>
            </a:lvl4pPr>
            <a:lvl5pPr>
              <a:defRPr sz="8300"/>
            </a:lvl5pPr>
            <a:lvl6pPr>
              <a:defRPr sz="8300"/>
            </a:lvl6pPr>
            <a:lvl7pPr>
              <a:defRPr sz="8300"/>
            </a:lvl7pPr>
            <a:lvl8pPr>
              <a:defRPr sz="8300"/>
            </a:lvl8pPr>
            <a:lvl9pPr>
              <a:defRPr sz="8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02432811" y="35726968"/>
            <a:ext cx="91503938" cy="101045127"/>
          </a:xfrm>
        </p:spPr>
        <p:txBody>
          <a:bodyPr/>
          <a:lstStyle>
            <a:lvl1pPr>
              <a:defRPr sz="13100"/>
            </a:lvl1pPr>
            <a:lvl2pPr>
              <a:defRPr sz="11100"/>
            </a:lvl2pPr>
            <a:lvl3pPr>
              <a:defRPr sz="9500"/>
            </a:lvl3pPr>
            <a:lvl4pPr>
              <a:defRPr sz="8300"/>
            </a:lvl4pPr>
            <a:lvl5pPr>
              <a:defRPr sz="8300"/>
            </a:lvl5pPr>
            <a:lvl6pPr>
              <a:defRPr sz="8300"/>
            </a:lvl6pPr>
            <a:lvl7pPr>
              <a:defRPr sz="8300"/>
            </a:lvl7pPr>
            <a:lvl8pPr>
              <a:defRPr sz="8300"/>
            </a:lvl8pPr>
            <a:lvl9pPr>
              <a:defRPr sz="8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2874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60270" y="1297665"/>
            <a:ext cx="38884860" cy="5400675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160282" y="7253409"/>
            <a:ext cx="19089887" cy="3022875"/>
          </a:xfrm>
        </p:spPr>
        <p:txBody>
          <a:bodyPr anchor="b"/>
          <a:lstStyle>
            <a:lvl1pPr marL="0" indent="0">
              <a:buNone/>
              <a:defRPr sz="11100" b="1"/>
            </a:lvl1pPr>
            <a:lvl2pPr marL="2158461" indent="0">
              <a:buNone/>
              <a:defRPr sz="9500" b="1"/>
            </a:lvl2pPr>
            <a:lvl3pPr marL="4316934" indent="0">
              <a:buNone/>
              <a:defRPr sz="8300" b="1"/>
            </a:lvl3pPr>
            <a:lvl4pPr marL="6475396" indent="0">
              <a:buNone/>
              <a:defRPr sz="7500" b="1"/>
            </a:lvl4pPr>
            <a:lvl5pPr marL="8633861" indent="0">
              <a:buNone/>
              <a:defRPr sz="7500" b="1"/>
            </a:lvl5pPr>
            <a:lvl6pPr marL="10792330" indent="0">
              <a:buNone/>
              <a:defRPr sz="7500" b="1"/>
            </a:lvl6pPr>
            <a:lvl7pPr marL="12950791" indent="0">
              <a:buNone/>
              <a:defRPr sz="7500" b="1"/>
            </a:lvl7pPr>
            <a:lvl8pPr marL="15109257" indent="0">
              <a:buNone/>
              <a:defRPr sz="7500" b="1"/>
            </a:lvl8pPr>
            <a:lvl9pPr marL="17267722" indent="0">
              <a:buNone/>
              <a:defRPr sz="75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160282" y="10276284"/>
            <a:ext cx="19089887" cy="18669836"/>
          </a:xfrm>
        </p:spPr>
        <p:txBody>
          <a:bodyPr/>
          <a:lstStyle>
            <a:lvl1pPr>
              <a:defRPr sz="11100"/>
            </a:lvl1pPr>
            <a:lvl2pPr>
              <a:defRPr sz="9500"/>
            </a:lvl2pPr>
            <a:lvl3pPr>
              <a:defRPr sz="8300"/>
            </a:lvl3pPr>
            <a:lvl4pPr>
              <a:defRPr sz="7500"/>
            </a:lvl4pPr>
            <a:lvl5pPr>
              <a:defRPr sz="7500"/>
            </a:lvl5pPr>
            <a:lvl6pPr>
              <a:defRPr sz="7500"/>
            </a:lvl6pPr>
            <a:lvl7pPr>
              <a:defRPr sz="7500"/>
            </a:lvl7pPr>
            <a:lvl8pPr>
              <a:defRPr sz="7500"/>
            </a:lvl8pPr>
            <a:lvl9pPr>
              <a:defRPr sz="7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21947749" y="7253409"/>
            <a:ext cx="19097386" cy="3022875"/>
          </a:xfrm>
        </p:spPr>
        <p:txBody>
          <a:bodyPr anchor="b"/>
          <a:lstStyle>
            <a:lvl1pPr marL="0" indent="0">
              <a:buNone/>
              <a:defRPr sz="11100" b="1"/>
            </a:lvl1pPr>
            <a:lvl2pPr marL="2158461" indent="0">
              <a:buNone/>
              <a:defRPr sz="9500" b="1"/>
            </a:lvl2pPr>
            <a:lvl3pPr marL="4316934" indent="0">
              <a:buNone/>
              <a:defRPr sz="8300" b="1"/>
            </a:lvl3pPr>
            <a:lvl4pPr marL="6475396" indent="0">
              <a:buNone/>
              <a:defRPr sz="7500" b="1"/>
            </a:lvl4pPr>
            <a:lvl5pPr marL="8633861" indent="0">
              <a:buNone/>
              <a:defRPr sz="7500" b="1"/>
            </a:lvl5pPr>
            <a:lvl6pPr marL="10792330" indent="0">
              <a:buNone/>
              <a:defRPr sz="7500" b="1"/>
            </a:lvl6pPr>
            <a:lvl7pPr marL="12950791" indent="0">
              <a:buNone/>
              <a:defRPr sz="7500" b="1"/>
            </a:lvl7pPr>
            <a:lvl8pPr marL="15109257" indent="0">
              <a:buNone/>
              <a:defRPr sz="7500" b="1"/>
            </a:lvl8pPr>
            <a:lvl9pPr marL="17267722" indent="0">
              <a:buNone/>
              <a:defRPr sz="75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21947749" y="10276284"/>
            <a:ext cx="19097386" cy="18669836"/>
          </a:xfrm>
        </p:spPr>
        <p:txBody>
          <a:bodyPr/>
          <a:lstStyle>
            <a:lvl1pPr>
              <a:defRPr sz="11100"/>
            </a:lvl1pPr>
            <a:lvl2pPr>
              <a:defRPr sz="9500"/>
            </a:lvl2pPr>
            <a:lvl3pPr>
              <a:defRPr sz="8300"/>
            </a:lvl3pPr>
            <a:lvl4pPr>
              <a:defRPr sz="7500"/>
            </a:lvl4pPr>
            <a:lvl5pPr>
              <a:defRPr sz="7500"/>
            </a:lvl5pPr>
            <a:lvl6pPr>
              <a:defRPr sz="7500"/>
            </a:lvl6pPr>
            <a:lvl7pPr>
              <a:defRPr sz="7500"/>
            </a:lvl7pPr>
            <a:lvl8pPr>
              <a:defRPr sz="7500"/>
            </a:lvl8pPr>
            <a:lvl9pPr>
              <a:defRPr sz="7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06941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36994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94948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60274" y="1290161"/>
            <a:ext cx="14214279" cy="5490686"/>
          </a:xfrm>
        </p:spPr>
        <p:txBody>
          <a:bodyPr anchor="b"/>
          <a:lstStyle>
            <a:lvl1pPr algn="l">
              <a:defRPr sz="9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16892115" y="1290182"/>
            <a:ext cx="24153020" cy="27655959"/>
          </a:xfrm>
        </p:spPr>
        <p:txBody>
          <a:bodyPr/>
          <a:lstStyle>
            <a:lvl1pPr>
              <a:defRPr sz="15100"/>
            </a:lvl1pPr>
            <a:lvl2pPr>
              <a:defRPr sz="13100"/>
            </a:lvl2pPr>
            <a:lvl3pPr>
              <a:defRPr sz="11100"/>
            </a:lvl3pPr>
            <a:lvl4pPr>
              <a:defRPr sz="9500"/>
            </a:lvl4pPr>
            <a:lvl5pPr>
              <a:defRPr sz="9500"/>
            </a:lvl5pPr>
            <a:lvl6pPr>
              <a:defRPr sz="9500"/>
            </a:lvl6pPr>
            <a:lvl7pPr>
              <a:defRPr sz="9500"/>
            </a:lvl7pPr>
            <a:lvl8pPr>
              <a:defRPr sz="9500"/>
            </a:lvl8pPr>
            <a:lvl9pPr>
              <a:defRPr sz="9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160274" y="6780869"/>
            <a:ext cx="14214279" cy="22165273"/>
          </a:xfrm>
        </p:spPr>
        <p:txBody>
          <a:bodyPr/>
          <a:lstStyle>
            <a:lvl1pPr marL="0" indent="0">
              <a:buNone/>
              <a:defRPr sz="6700"/>
            </a:lvl1pPr>
            <a:lvl2pPr marL="2158461" indent="0">
              <a:buNone/>
              <a:defRPr sz="5600"/>
            </a:lvl2pPr>
            <a:lvl3pPr marL="4316934" indent="0">
              <a:buNone/>
              <a:defRPr sz="4800"/>
            </a:lvl3pPr>
            <a:lvl4pPr marL="6475396" indent="0">
              <a:buNone/>
              <a:defRPr sz="4400"/>
            </a:lvl4pPr>
            <a:lvl5pPr marL="8633861" indent="0">
              <a:buNone/>
              <a:defRPr sz="4400"/>
            </a:lvl5pPr>
            <a:lvl6pPr marL="10792330" indent="0">
              <a:buNone/>
              <a:defRPr sz="4400"/>
            </a:lvl6pPr>
            <a:lvl7pPr marL="12950791" indent="0">
              <a:buNone/>
              <a:defRPr sz="4400"/>
            </a:lvl7pPr>
            <a:lvl8pPr marL="15109257" indent="0">
              <a:buNone/>
              <a:defRPr sz="4400"/>
            </a:lvl8pPr>
            <a:lvl9pPr marL="17267722" indent="0">
              <a:buNone/>
              <a:defRPr sz="44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15388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468560" y="22682835"/>
            <a:ext cx="25923240" cy="2677837"/>
          </a:xfrm>
        </p:spPr>
        <p:txBody>
          <a:bodyPr anchor="b"/>
          <a:lstStyle>
            <a:lvl1pPr algn="l">
              <a:defRPr sz="95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8468560" y="2895362"/>
            <a:ext cx="25923240" cy="19442430"/>
          </a:xfrm>
        </p:spPr>
        <p:txBody>
          <a:bodyPr/>
          <a:lstStyle>
            <a:lvl1pPr marL="0" indent="0">
              <a:buNone/>
              <a:defRPr sz="15100"/>
            </a:lvl1pPr>
            <a:lvl2pPr marL="2158461" indent="0">
              <a:buNone/>
              <a:defRPr sz="13100"/>
            </a:lvl2pPr>
            <a:lvl3pPr marL="4316934" indent="0">
              <a:buNone/>
              <a:defRPr sz="11100"/>
            </a:lvl3pPr>
            <a:lvl4pPr marL="6475396" indent="0">
              <a:buNone/>
              <a:defRPr sz="9500"/>
            </a:lvl4pPr>
            <a:lvl5pPr marL="8633861" indent="0">
              <a:buNone/>
              <a:defRPr sz="9500"/>
            </a:lvl5pPr>
            <a:lvl6pPr marL="10792330" indent="0">
              <a:buNone/>
              <a:defRPr sz="9500"/>
            </a:lvl6pPr>
            <a:lvl7pPr marL="12950791" indent="0">
              <a:buNone/>
              <a:defRPr sz="9500"/>
            </a:lvl7pPr>
            <a:lvl8pPr marL="15109257" indent="0">
              <a:buNone/>
              <a:defRPr sz="9500"/>
            </a:lvl8pPr>
            <a:lvl9pPr marL="17267722" indent="0">
              <a:buNone/>
              <a:defRPr sz="95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468560" y="25360672"/>
            <a:ext cx="25923240" cy="3802973"/>
          </a:xfrm>
        </p:spPr>
        <p:txBody>
          <a:bodyPr/>
          <a:lstStyle>
            <a:lvl1pPr marL="0" indent="0">
              <a:buNone/>
              <a:defRPr sz="6700"/>
            </a:lvl1pPr>
            <a:lvl2pPr marL="2158461" indent="0">
              <a:buNone/>
              <a:defRPr sz="5600"/>
            </a:lvl2pPr>
            <a:lvl3pPr marL="4316934" indent="0">
              <a:buNone/>
              <a:defRPr sz="4800"/>
            </a:lvl3pPr>
            <a:lvl4pPr marL="6475396" indent="0">
              <a:buNone/>
              <a:defRPr sz="4400"/>
            </a:lvl4pPr>
            <a:lvl5pPr marL="8633861" indent="0">
              <a:buNone/>
              <a:defRPr sz="4400"/>
            </a:lvl5pPr>
            <a:lvl6pPr marL="10792330" indent="0">
              <a:buNone/>
              <a:defRPr sz="4400"/>
            </a:lvl6pPr>
            <a:lvl7pPr marL="12950791" indent="0">
              <a:buNone/>
              <a:defRPr sz="4400"/>
            </a:lvl7pPr>
            <a:lvl8pPr marL="15109257" indent="0">
              <a:buNone/>
              <a:defRPr sz="4400"/>
            </a:lvl8pPr>
            <a:lvl9pPr marL="17267722" indent="0">
              <a:buNone/>
              <a:defRPr sz="44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92781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2160270" y="1297665"/>
            <a:ext cx="38884860" cy="5400675"/>
          </a:xfrm>
          <a:prstGeom prst="rect">
            <a:avLst/>
          </a:prstGeom>
        </p:spPr>
        <p:txBody>
          <a:bodyPr vert="horz" lIns="431688" tIns="215850" rIns="431688" bIns="21585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2160270" y="7560966"/>
            <a:ext cx="38884860" cy="21385175"/>
          </a:xfrm>
          <a:prstGeom prst="rect">
            <a:avLst/>
          </a:prstGeom>
        </p:spPr>
        <p:txBody>
          <a:bodyPr vert="horz" lIns="431688" tIns="215850" rIns="431688" bIns="21585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2160270" y="30033765"/>
            <a:ext cx="10081260" cy="1725216"/>
          </a:xfrm>
          <a:prstGeom prst="rect">
            <a:avLst/>
          </a:prstGeom>
        </p:spPr>
        <p:txBody>
          <a:bodyPr vert="horz" lIns="431688" tIns="215850" rIns="431688" bIns="215850" rtlCol="0" anchor="ctr"/>
          <a:lstStyle>
            <a:lvl1pPr algn="l">
              <a:defRPr sz="5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A734B-47AF-4789-AE1F-A71E94F00BC2}" type="datetimeFigureOut">
              <a:rPr lang="ko-KR" altLang="en-US" smtClean="0"/>
              <a:t>2021-10-22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14761845" y="30033765"/>
            <a:ext cx="13681710" cy="1725216"/>
          </a:xfrm>
          <a:prstGeom prst="rect">
            <a:avLst/>
          </a:prstGeom>
        </p:spPr>
        <p:txBody>
          <a:bodyPr vert="horz" lIns="431688" tIns="215850" rIns="431688" bIns="215850" rtlCol="0" anchor="ctr"/>
          <a:lstStyle>
            <a:lvl1pPr algn="ctr">
              <a:defRPr sz="5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30963870" y="30033765"/>
            <a:ext cx="10081260" cy="1725216"/>
          </a:xfrm>
          <a:prstGeom prst="rect">
            <a:avLst/>
          </a:prstGeom>
        </p:spPr>
        <p:txBody>
          <a:bodyPr vert="horz" lIns="431688" tIns="215850" rIns="431688" bIns="215850" rtlCol="0" anchor="ctr"/>
          <a:lstStyle>
            <a:lvl1pPr algn="r">
              <a:defRPr sz="5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E6F0D9-F04B-4CF5-8909-6C05F1039C47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95381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316934" rtl="0" eaLnBrk="1" latinLnBrk="1" hangingPunct="1">
        <a:spcBef>
          <a:spcPct val="0"/>
        </a:spcBef>
        <a:buNone/>
        <a:defRPr sz="20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18852" indent="-1618852" algn="l" defTabSz="4316934" rtl="0" eaLnBrk="1" latinLnBrk="1" hangingPunct="1">
        <a:spcBef>
          <a:spcPct val="20000"/>
        </a:spcBef>
        <a:buFont typeface="Arial" panose="020B0604020202020204" pitchFamily="34" charset="0"/>
        <a:buChar char="•"/>
        <a:defRPr sz="15100" kern="1200">
          <a:solidFill>
            <a:schemeClr val="tx1"/>
          </a:solidFill>
          <a:latin typeface="+mn-lt"/>
          <a:ea typeface="+mn-ea"/>
          <a:cs typeface="+mn-cs"/>
        </a:defRPr>
      </a:lvl1pPr>
      <a:lvl2pPr marL="3507505" indent="-1349043" algn="l" defTabSz="4316934" rtl="0" eaLnBrk="1" latinLnBrk="1" hangingPunct="1">
        <a:spcBef>
          <a:spcPct val="20000"/>
        </a:spcBef>
        <a:buFont typeface="Arial" panose="020B0604020202020204" pitchFamily="34" charset="0"/>
        <a:buChar char="–"/>
        <a:defRPr sz="13100" kern="1200">
          <a:solidFill>
            <a:schemeClr val="tx1"/>
          </a:solidFill>
          <a:latin typeface="+mn-lt"/>
          <a:ea typeface="+mn-ea"/>
          <a:cs typeface="+mn-cs"/>
        </a:defRPr>
      </a:lvl2pPr>
      <a:lvl3pPr marL="5396165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•"/>
        <a:defRPr sz="11100" kern="1200">
          <a:solidFill>
            <a:schemeClr val="tx1"/>
          </a:solidFill>
          <a:latin typeface="+mn-lt"/>
          <a:ea typeface="+mn-ea"/>
          <a:cs typeface="+mn-cs"/>
        </a:defRPr>
      </a:lvl3pPr>
      <a:lvl4pPr marL="7554626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–"/>
        <a:defRPr sz="9500" kern="1200">
          <a:solidFill>
            <a:schemeClr val="tx1"/>
          </a:solidFill>
          <a:latin typeface="+mn-lt"/>
          <a:ea typeface="+mn-ea"/>
          <a:cs typeface="+mn-cs"/>
        </a:defRPr>
      </a:lvl4pPr>
      <a:lvl5pPr marL="9713096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»"/>
        <a:defRPr sz="9500" kern="1200">
          <a:solidFill>
            <a:schemeClr val="tx1"/>
          </a:solidFill>
          <a:latin typeface="+mn-lt"/>
          <a:ea typeface="+mn-ea"/>
          <a:cs typeface="+mn-cs"/>
        </a:defRPr>
      </a:lvl5pPr>
      <a:lvl6pPr marL="11871561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6pPr>
      <a:lvl7pPr marL="14030022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7pPr>
      <a:lvl8pPr marL="16188487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8pPr>
      <a:lvl9pPr marL="18346957" indent="-1079231" algn="l" defTabSz="4316934" rtl="0" eaLnBrk="1" latinLnBrk="1" hangingPunct="1">
        <a:spcBef>
          <a:spcPct val="20000"/>
        </a:spcBef>
        <a:buFont typeface="Arial" panose="020B0604020202020204" pitchFamily="34" charset="0"/>
        <a:buChar char="•"/>
        <a:defRPr sz="9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1pPr>
      <a:lvl2pPr marL="2158461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2pPr>
      <a:lvl3pPr marL="4316934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3pPr>
      <a:lvl4pPr marL="6475396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4pPr>
      <a:lvl5pPr marL="8633861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5pPr>
      <a:lvl6pPr marL="10792330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6pPr>
      <a:lvl7pPr marL="12950791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7pPr>
      <a:lvl8pPr marL="15109257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8pPr>
      <a:lvl9pPr marL="17267722" algn="l" defTabSz="4316934" rtl="0" eaLnBrk="1" latinLnBrk="1" hangingPunct="1">
        <a:defRPr sz="8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2.png"/><Relationship Id="rId7" Type="http://schemas.openxmlformats.org/officeDocument/2006/relationships/chart" Target="../charts/chart2.xml"/><Relationship Id="rId12" Type="http://schemas.openxmlformats.org/officeDocument/2006/relationships/chart" Target="../charts/chart7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1.xml"/><Relationship Id="rId11" Type="http://schemas.openxmlformats.org/officeDocument/2006/relationships/chart" Target="../charts/chart6.xml"/><Relationship Id="rId5" Type="http://schemas.openxmlformats.org/officeDocument/2006/relationships/image" Target="../media/image4.png"/><Relationship Id="rId10" Type="http://schemas.openxmlformats.org/officeDocument/2006/relationships/chart" Target="../charts/chart5.xml"/><Relationship Id="rId4" Type="http://schemas.openxmlformats.org/officeDocument/2006/relationships/image" Target="../media/image3.png"/><Relationship Id="rId9" Type="http://schemas.openxmlformats.org/officeDocument/2006/relationships/chart" Target="../charts/chart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7" Type="http://schemas.openxmlformats.org/officeDocument/2006/relationships/chart" Target="../charts/chart13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10992" y="69668"/>
            <a:ext cx="42202020" cy="1123318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700" b="1" dirty="0"/>
              <a:t>Supplementary Fig</a:t>
            </a:r>
            <a:r>
              <a:rPr lang="en-US" altLang="zh-CN" sz="6700" b="1" dirty="0"/>
              <a:t>ure</a:t>
            </a:r>
            <a:r>
              <a:rPr lang="en-US" altLang="ko-KR" sz="6700" b="1" dirty="0"/>
              <a:t>. S1. 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The expression of clock genes ((</a:t>
            </a:r>
            <a:r>
              <a:rPr lang="en-US" altLang="ko-KR" sz="67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), (</a:t>
            </a:r>
            <a:r>
              <a:rPr lang="en-US" altLang="ko-KR" sz="67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), and (</a:t>
            </a:r>
            <a:r>
              <a:rPr lang="en-US" altLang="ko-KR" sz="67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)) and light signal genes ((</a:t>
            </a:r>
            <a:r>
              <a:rPr lang="en-US" altLang="ko-KR" sz="67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), (</a:t>
            </a:r>
            <a:r>
              <a:rPr lang="en-US" altLang="ko-KR" sz="670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), and (</a:t>
            </a:r>
            <a:r>
              <a:rPr lang="en-US" altLang="ko-KR" sz="6700" b="1" dirty="0"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ko-KR" sz="6700" dirty="0">
                <a:latin typeface="Times New Roman" pitchFamily="18" charset="0"/>
                <a:cs typeface="Times New Roman" pitchFamily="18" charset="0"/>
              </a:rPr>
              <a:t>)) </a:t>
            </a:r>
            <a:endParaRPr lang="ko-KR" altLang="en-US" sz="67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7954" y="3887393"/>
            <a:ext cx="1945238" cy="1107929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600" dirty="0">
                <a:latin typeface="Times New Roman" pitchFamily="18" charset="0"/>
                <a:cs typeface="Times New Roman" pitchFamily="18" charset="0"/>
              </a:rPr>
              <a:t>(A)</a:t>
            </a:r>
            <a:endParaRPr lang="ko-KR" altLang="en-US" sz="6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081420" y="3791143"/>
            <a:ext cx="1512168" cy="1107929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600" dirty="0">
                <a:latin typeface="Times New Roman" pitchFamily="18" charset="0"/>
                <a:cs typeface="Times New Roman" pitchFamily="18" charset="0"/>
              </a:rPr>
              <a:t>(B)</a:t>
            </a:r>
            <a:endParaRPr lang="ko-KR" altLang="en-US" sz="6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648372" y="4347907"/>
            <a:ext cx="9138338" cy="26480449"/>
            <a:chOff x="14617924" y="2909011"/>
            <a:chExt cx="10729192" cy="26480449"/>
          </a:xfrm>
        </p:grpSpPr>
        <p:pic>
          <p:nvPicPr>
            <p:cNvPr id="28" name="그림 2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17924" y="4752754"/>
              <a:ext cx="10729192" cy="24636706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4478590" y="5278656"/>
              <a:ext cx="3844800" cy="2160000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 rot="16200000">
              <a:off x="18907418" y="3231013"/>
              <a:ext cx="2952328" cy="230832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03_1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03_2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03_3</a:t>
              </a:r>
              <a:endParaRPr lang="ko-KR" altLang="en-US" sz="4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21568730" y="3231013"/>
              <a:ext cx="2952328" cy="230832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K1_1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K1_2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K1_3</a:t>
              </a: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10832864" y="4238252"/>
            <a:ext cx="9433048" cy="26868165"/>
            <a:chOff x="30385641" y="2799356"/>
            <a:chExt cx="11233248" cy="26868165"/>
          </a:xfrm>
        </p:grpSpPr>
        <p:pic>
          <p:nvPicPr>
            <p:cNvPr id="25" name="그림 2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385641" y="4896769"/>
              <a:ext cx="11233248" cy="24770752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 rot="16200000">
              <a:off x="34686300" y="3242438"/>
              <a:ext cx="3247562" cy="23613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72000" bIns="72000" rtlCol="0">
              <a:spAutoFit/>
            </a:bodyPr>
            <a:lstStyle/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03_1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03_2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H03_3</a:t>
              </a:r>
              <a:endParaRPr lang="ko-KR" altLang="en-US" sz="4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37376284" y="3242438"/>
              <a:ext cx="3247562" cy="23613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72000" bIns="72000" rtlCol="0">
              <a:spAutoFit/>
            </a:bodyPr>
            <a:lstStyle/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K1_1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K1_2</a:t>
              </a:r>
            </a:p>
            <a:p>
              <a:r>
                <a:rPr lang="en-US" altLang="ko-KR" sz="4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K1_3</a:t>
              </a:r>
            </a:p>
          </p:txBody>
        </p:sp>
        <p:pic>
          <p:nvPicPr>
            <p:cNvPr id="27" name="그림 26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0843994" y="5304548"/>
              <a:ext cx="3833054" cy="2153401"/>
            </a:xfrm>
            <a:prstGeom prst="rect">
              <a:avLst/>
            </a:prstGeom>
          </p:spPr>
        </p:pic>
      </p:grpSp>
      <p:graphicFrame>
        <p:nvGraphicFramePr>
          <p:cNvPr id="29" name="차트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403181"/>
              </p:ext>
            </p:extLst>
          </p:nvPr>
        </p:nvGraphicFramePr>
        <p:xfrm>
          <a:off x="21270629" y="2381634"/>
          <a:ext cx="13722119" cy="133883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0" name="차트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7287483"/>
              </p:ext>
            </p:extLst>
          </p:nvPr>
        </p:nvGraphicFramePr>
        <p:xfrm>
          <a:off x="35191496" y="2381634"/>
          <a:ext cx="7725572" cy="129065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3" name="그룹 2"/>
          <p:cNvGrpSpPr/>
          <p:nvPr/>
        </p:nvGrpSpPr>
        <p:grpSpPr>
          <a:xfrm>
            <a:off x="21693074" y="23534787"/>
            <a:ext cx="6199036" cy="8941046"/>
            <a:chOff x="22710864" y="14727888"/>
            <a:chExt cx="6199036" cy="8941046"/>
          </a:xfrm>
        </p:grpSpPr>
        <p:graphicFrame>
          <p:nvGraphicFramePr>
            <p:cNvPr id="32" name="차트 3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90128807"/>
                </p:ext>
              </p:extLst>
            </p:nvPr>
          </p:nvGraphicFramePr>
          <p:xfrm>
            <a:off x="22710864" y="14727888"/>
            <a:ext cx="6199036" cy="89410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cxnSp>
          <p:nvCxnSpPr>
            <p:cNvPr id="37" name="직선 연결선 36"/>
            <p:cNvCxnSpPr/>
            <p:nvPr/>
          </p:nvCxnSpPr>
          <p:spPr>
            <a:xfrm flipV="1">
              <a:off x="25575681" y="17757085"/>
              <a:ext cx="1674769" cy="1441791"/>
            </a:xfrm>
            <a:prstGeom prst="line">
              <a:avLst/>
            </a:prstGeom>
            <a:ln w="12700">
              <a:solidFill>
                <a:srgbClr val="FF0000"/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그룹 1"/>
          <p:cNvGrpSpPr/>
          <p:nvPr/>
        </p:nvGrpSpPr>
        <p:grpSpPr>
          <a:xfrm>
            <a:off x="20724509" y="15597016"/>
            <a:ext cx="22719261" cy="9173961"/>
            <a:chOff x="29160365" y="15365980"/>
            <a:chExt cx="22719261" cy="9173961"/>
          </a:xfrm>
        </p:grpSpPr>
        <p:sp>
          <p:nvSpPr>
            <p:cNvPr id="31" name="TextBox 30"/>
            <p:cNvSpPr txBox="1"/>
            <p:nvPr/>
          </p:nvSpPr>
          <p:spPr>
            <a:xfrm>
              <a:off x="29599425" y="15925175"/>
              <a:ext cx="184732" cy="13696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dirty="0"/>
            </a:p>
          </p:txBody>
        </p:sp>
        <p:graphicFrame>
          <p:nvGraphicFramePr>
            <p:cNvPr id="33" name="차트 3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65622185"/>
                </p:ext>
              </p:extLst>
            </p:nvPr>
          </p:nvGraphicFramePr>
          <p:xfrm>
            <a:off x="29160365" y="15394954"/>
            <a:ext cx="5471323" cy="874619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34" name="차트 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17941698"/>
                </p:ext>
              </p:extLst>
            </p:nvPr>
          </p:nvGraphicFramePr>
          <p:xfrm>
            <a:off x="34492132" y="15409937"/>
            <a:ext cx="5941777" cy="87162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35" name="차트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63365161"/>
                </p:ext>
              </p:extLst>
            </p:nvPr>
          </p:nvGraphicFramePr>
          <p:xfrm>
            <a:off x="40466827" y="15365980"/>
            <a:ext cx="5579131" cy="83029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36" name="차트 3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23121583"/>
                </p:ext>
              </p:extLst>
            </p:nvPr>
          </p:nvGraphicFramePr>
          <p:xfrm>
            <a:off x="46159606" y="15365980"/>
            <a:ext cx="5720020" cy="91739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cxnSp>
          <p:nvCxnSpPr>
            <p:cNvPr id="38" name="직선 연결선 37"/>
            <p:cNvCxnSpPr/>
            <p:nvPr/>
          </p:nvCxnSpPr>
          <p:spPr>
            <a:xfrm flipV="1">
              <a:off x="37182550" y="17947229"/>
              <a:ext cx="1679677" cy="861037"/>
            </a:xfrm>
            <a:prstGeom prst="line">
              <a:avLst/>
            </a:prstGeom>
            <a:ln w="12700">
              <a:solidFill>
                <a:srgbClr val="FF0000"/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직선 연결선 38"/>
            <p:cNvCxnSpPr/>
            <p:nvPr/>
          </p:nvCxnSpPr>
          <p:spPr>
            <a:xfrm flipV="1">
              <a:off x="42566357" y="17406826"/>
              <a:ext cx="1778020" cy="1435601"/>
            </a:xfrm>
            <a:prstGeom prst="line">
              <a:avLst/>
            </a:prstGeom>
            <a:ln w="12700">
              <a:solidFill>
                <a:srgbClr val="FF0000"/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연결선 39"/>
            <p:cNvCxnSpPr/>
            <p:nvPr/>
          </p:nvCxnSpPr>
          <p:spPr>
            <a:xfrm>
              <a:off x="48305832" y="20068574"/>
              <a:ext cx="1771925" cy="514982"/>
            </a:xfrm>
            <a:prstGeom prst="line">
              <a:avLst/>
            </a:prstGeom>
            <a:ln w="12700">
              <a:solidFill>
                <a:srgbClr val="FF0000"/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/>
            <p:cNvCxnSpPr/>
            <p:nvPr/>
          </p:nvCxnSpPr>
          <p:spPr>
            <a:xfrm>
              <a:off x="31430410" y="20326068"/>
              <a:ext cx="1597055" cy="257489"/>
            </a:xfrm>
            <a:prstGeom prst="line">
              <a:avLst/>
            </a:prstGeom>
            <a:ln w="12700">
              <a:solidFill>
                <a:srgbClr val="FF0000"/>
              </a:solidFill>
              <a:headEnd type="oval" w="med" len="med"/>
              <a:tailEnd type="oval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TextBox 41"/>
          <p:cNvSpPr txBox="1"/>
          <p:nvPr/>
        </p:nvSpPr>
        <p:spPr>
          <a:xfrm>
            <a:off x="20231341" y="3706314"/>
            <a:ext cx="1512168" cy="1107929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600" dirty="0">
                <a:latin typeface="Times New Roman" pitchFamily="18" charset="0"/>
                <a:cs typeface="Times New Roman" pitchFamily="18" charset="0"/>
              </a:rPr>
              <a:t>(C)</a:t>
            </a:r>
            <a:endParaRPr lang="ko-KR" altLang="en-US" sz="6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3900890" y="3706313"/>
            <a:ext cx="1512168" cy="1107929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600" dirty="0">
                <a:latin typeface="Times New Roman" pitchFamily="18" charset="0"/>
                <a:cs typeface="Times New Roman" pitchFamily="18" charset="0"/>
              </a:rPr>
              <a:t>(D)</a:t>
            </a:r>
            <a:endParaRPr lang="ko-KR" altLang="en-US" sz="6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0911038" y="14536689"/>
            <a:ext cx="1512168" cy="1107929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600" dirty="0">
                <a:latin typeface="Times New Roman" pitchFamily="18" charset="0"/>
                <a:cs typeface="Times New Roman" pitchFamily="18" charset="0"/>
              </a:rPr>
              <a:t>(E)</a:t>
            </a:r>
            <a:endParaRPr lang="ko-KR" altLang="en-US" sz="6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0936990" y="24035109"/>
            <a:ext cx="1512168" cy="1107929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600" dirty="0">
                <a:latin typeface="Times New Roman" pitchFamily="18" charset="0"/>
                <a:cs typeface="Times New Roman" pitchFamily="18" charset="0"/>
              </a:rPr>
              <a:t>(F)</a:t>
            </a:r>
            <a:endParaRPr lang="ko-KR" altLang="en-US" sz="6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3537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차트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8918870"/>
              </p:ext>
            </p:extLst>
          </p:nvPr>
        </p:nvGraphicFramePr>
        <p:xfrm>
          <a:off x="2160540" y="15736445"/>
          <a:ext cx="11272936" cy="86024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차트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15377597"/>
              </p:ext>
            </p:extLst>
          </p:nvPr>
        </p:nvGraphicFramePr>
        <p:xfrm>
          <a:off x="14412850" y="15697969"/>
          <a:ext cx="11449272" cy="8424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0793282"/>
              </p:ext>
            </p:extLst>
          </p:nvPr>
        </p:nvGraphicFramePr>
        <p:xfrm>
          <a:off x="2894019" y="5400825"/>
          <a:ext cx="10225136" cy="720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차트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0008097"/>
              </p:ext>
            </p:extLst>
          </p:nvPr>
        </p:nvGraphicFramePr>
        <p:xfrm>
          <a:off x="14470451" y="5338342"/>
          <a:ext cx="10225136" cy="720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차트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5324192"/>
              </p:ext>
            </p:extLst>
          </p:nvPr>
        </p:nvGraphicFramePr>
        <p:xfrm>
          <a:off x="27389936" y="5302988"/>
          <a:ext cx="10225136" cy="720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" name="직사각형 6"/>
          <p:cNvSpPr/>
          <p:nvPr/>
        </p:nvSpPr>
        <p:spPr>
          <a:xfrm rot="16200000">
            <a:off x="1227288" y="7338372"/>
            <a:ext cx="2426242" cy="9048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5280" b="1" i="0" u="none" strike="noStrike" kern="1200" baseline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en-US" dirty="0"/>
              <a:t>Sucrose</a:t>
            </a:r>
          </a:p>
        </p:txBody>
      </p:sp>
      <p:sp>
        <p:nvSpPr>
          <p:cNvPr id="8" name="직사각형 7"/>
          <p:cNvSpPr/>
          <p:nvPr/>
        </p:nvSpPr>
        <p:spPr>
          <a:xfrm rot="16200000">
            <a:off x="13249851" y="7501493"/>
            <a:ext cx="2247731" cy="7571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432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dirty="0"/>
              <a:t>Glucose</a:t>
            </a:r>
          </a:p>
        </p:txBody>
      </p:sp>
      <p:sp>
        <p:nvSpPr>
          <p:cNvPr id="10" name="직사각형 9"/>
          <p:cNvSpPr/>
          <p:nvPr/>
        </p:nvSpPr>
        <p:spPr>
          <a:xfrm rot="16200000">
            <a:off x="25787656" y="7741906"/>
            <a:ext cx="2414956" cy="7571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432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dirty="0"/>
              <a:t>Fructos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224436" y="5302988"/>
            <a:ext cx="1461697" cy="981718"/>
          </a:xfrm>
          <a:prstGeom prst="rect">
            <a:avLst/>
          </a:prstGeom>
          <a:noFill/>
        </p:spPr>
        <p:txBody>
          <a:bodyPr wrap="none" lIns="362624" tIns="181312" rIns="362624" bIns="181312" rtlCol="0">
            <a:spAutoFit/>
          </a:bodyPr>
          <a:lstStyle/>
          <a:p>
            <a:pPr defTabSz="3626221"/>
            <a:r>
              <a:rPr lang="en-US" altLang="ko-KR" sz="4000" b="1" dirty="0">
                <a:solidFill>
                  <a:prstClr val="black"/>
                </a:solidFill>
              </a:rPr>
              <a:t>(A)</a:t>
            </a:r>
            <a:endParaRPr lang="ko-KR" altLang="en-US" sz="4000" b="1" dirty="0">
              <a:solidFill>
                <a:prstClr val="black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945682" y="5308672"/>
            <a:ext cx="1428034" cy="981718"/>
          </a:xfrm>
          <a:prstGeom prst="rect">
            <a:avLst/>
          </a:prstGeom>
          <a:noFill/>
        </p:spPr>
        <p:txBody>
          <a:bodyPr wrap="none" lIns="362624" tIns="181312" rIns="362624" bIns="181312" rtlCol="0">
            <a:spAutoFit/>
          </a:bodyPr>
          <a:lstStyle/>
          <a:p>
            <a:pPr defTabSz="3626221"/>
            <a:r>
              <a:rPr lang="en-US" altLang="ko-KR" sz="4000" b="1" dirty="0">
                <a:solidFill>
                  <a:prstClr val="black"/>
                </a:solidFill>
              </a:rPr>
              <a:t>(B)</a:t>
            </a:r>
            <a:endParaRPr lang="ko-KR" altLang="en-US" sz="4000" b="1" dirty="0">
              <a:solidFill>
                <a:prstClr val="black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567100" y="5308672"/>
            <a:ext cx="1428034" cy="981718"/>
          </a:xfrm>
          <a:prstGeom prst="rect">
            <a:avLst/>
          </a:prstGeom>
          <a:noFill/>
        </p:spPr>
        <p:txBody>
          <a:bodyPr wrap="none" lIns="362624" tIns="181312" rIns="362624" bIns="181312" rtlCol="0">
            <a:spAutoFit/>
          </a:bodyPr>
          <a:lstStyle/>
          <a:p>
            <a:pPr defTabSz="3626221"/>
            <a:r>
              <a:rPr lang="en-US" altLang="ko-KR" sz="4000" b="1" dirty="0">
                <a:solidFill>
                  <a:prstClr val="black"/>
                </a:solidFill>
              </a:rPr>
              <a:t>(C)</a:t>
            </a:r>
            <a:endParaRPr lang="ko-KR" altLang="en-US" sz="4000" b="1" dirty="0">
              <a:solidFill>
                <a:prstClr val="black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24436" y="15292315"/>
            <a:ext cx="1484139" cy="981718"/>
          </a:xfrm>
          <a:prstGeom prst="rect">
            <a:avLst/>
          </a:prstGeom>
          <a:noFill/>
        </p:spPr>
        <p:txBody>
          <a:bodyPr wrap="none" lIns="362624" tIns="181312" rIns="362624" bIns="181312" rtlCol="0">
            <a:spAutoFit/>
          </a:bodyPr>
          <a:lstStyle/>
          <a:p>
            <a:pPr defTabSz="3626221"/>
            <a:r>
              <a:rPr lang="en-US" altLang="ko-KR" sz="4000" b="1" dirty="0">
                <a:solidFill>
                  <a:prstClr val="black"/>
                </a:solidFill>
              </a:rPr>
              <a:t>(D)</a:t>
            </a:r>
            <a:endParaRPr lang="ko-KR" altLang="en-US" sz="4000" b="1" dirty="0">
              <a:solidFill>
                <a:prstClr val="black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3438397" y="15292315"/>
            <a:ext cx="1370326" cy="981718"/>
          </a:xfrm>
          <a:prstGeom prst="rect">
            <a:avLst/>
          </a:prstGeom>
          <a:noFill/>
        </p:spPr>
        <p:txBody>
          <a:bodyPr wrap="none" lIns="362624" tIns="181312" rIns="362624" bIns="181312" rtlCol="0">
            <a:spAutoFit/>
          </a:bodyPr>
          <a:lstStyle/>
          <a:p>
            <a:pPr defTabSz="3626221"/>
            <a:r>
              <a:rPr lang="en-US" altLang="ko-KR" sz="4000" b="1" dirty="0">
                <a:solidFill>
                  <a:prstClr val="black"/>
                </a:solidFill>
              </a:rPr>
              <a:t>(E)</a:t>
            </a:r>
            <a:endParaRPr lang="ko-KR" altLang="en-US" sz="4000" b="1" dirty="0">
              <a:solidFill>
                <a:prstClr val="black"/>
              </a:solidFill>
            </a:endParaRPr>
          </a:p>
        </p:txBody>
      </p:sp>
      <p:sp>
        <p:nvSpPr>
          <p:cNvPr id="20" name="직사각형 19"/>
          <p:cNvSpPr/>
          <p:nvPr/>
        </p:nvSpPr>
        <p:spPr>
          <a:xfrm rot="16200000">
            <a:off x="291832" y="18725805"/>
            <a:ext cx="4132413" cy="7571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432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dirty="0"/>
              <a:t>Total flavonoid</a:t>
            </a:r>
          </a:p>
        </p:txBody>
      </p:sp>
      <p:sp>
        <p:nvSpPr>
          <p:cNvPr id="21" name="직사각형 20"/>
          <p:cNvSpPr/>
          <p:nvPr/>
        </p:nvSpPr>
        <p:spPr>
          <a:xfrm rot="16200000">
            <a:off x="11886305" y="18968819"/>
            <a:ext cx="4618444" cy="7571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432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dirty="0"/>
              <a:t>Total polyphenol</a:t>
            </a:r>
          </a:p>
        </p:txBody>
      </p:sp>
      <p:graphicFrame>
        <p:nvGraphicFramePr>
          <p:cNvPr id="27" name="차트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27544"/>
              </p:ext>
            </p:extLst>
          </p:nvPr>
        </p:nvGraphicFramePr>
        <p:xfrm>
          <a:off x="28227436" y="15783173"/>
          <a:ext cx="8712968" cy="8123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0" name="직사각형 29"/>
          <p:cNvSpPr/>
          <p:nvPr/>
        </p:nvSpPr>
        <p:spPr>
          <a:xfrm rot="16200000">
            <a:off x="25994060" y="18375780"/>
            <a:ext cx="2656368" cy="7571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432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altLang="en-US" dirty="0"/>
              <a:t>Total GSL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6067196" y="15292315"/>
            <a:ext cx="1370326" cy="981718"/>
          </a:xfrm>
          <a:prstGeom prst="rect">
            <a:avLst/>
          </a:prstGeom>
          <a:noFill/>
        </p:spPr>
        <p:txBody>
          <a:bodyPr wrap="none" lIns="362624" tIns="181312" rIns="362624" bIns="181312" rtlCol="0">
            <a:spAutoFit/>
          </a:bodyPr>
          <a:lstStyle/>
          <a:p>
            <a:pPr defTabSz="3626221"/>
            <a:r>
              <a:rPr lang="en-US" altLang="ko-KR" sz="4000" b="1" dirty="0">
                <a:solidFill>
                  <a:prstClr val="black"/>
                </a:solidFill>
              </a:rPr>
              <a:t>(F)</a:t>
            </a:r>
            <a:endParaRPr lang="ko-KR" altLang="en-US" sz="4000" b="1" dirty="0">
              <a:solidFill>
                <a:prstClr val="black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46306" y="501922"/>
            <a:ext cx="42166706" cy="2308258"/>
          </a:xfrm>
          <a:prstGeom prst="rect">
            <a:avLst/>
          </a:prstGeom>
          <a:noFill/>
        </p:spPr>
        <p:txBody>
          <a:bodyPr wrap="square" lIns="91362" tIns="45687" rIns="91362" bIns="45687" rtlCol="0">
            <a:spAutoFit/>
          </a:bodyPr>
          <a:lstStyle/>
          <a:p>
            <a:r>
              <a:rPr lang="en-US" altLang="ko-KR" sz="6700" b="1" dirty="0"/>
              <a:t>Supplementary Figure. S2 </a:t>
            </a:r>
            <a:r>
              <a:rPr lang="en-US" altLang="ko-KR" sz="7200" dirty="0">
                <a:latin typeface="Times New Roman" pitchFamily="18" charset="0"/>
                <a:cs typeface="Times New Roman" pitchFamily="18" charset="0"/>
              </a:rPr>
              <a:t>Diurnal accumulation of primary ((A),(B), and (C)) and secondary metabolite ((D),(E), and (F)) contents and in DH03 and GK1 Chinese cabbage sprouts grown in 16-/8-h light/dark condition.</a:t>
            </a:r>
            <a:endParaRPr lang="ko-KR" altLang="en-US" sz="67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771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012</TotalTime>
  <Words>189</Words>
  <Application>Microsoft Office PowerPoint</Application>
  <PresentationFormat>Custom</PresentationFormat>
  <Paragraphs>4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맑은 고딕</vt:lpstr>
      <vt:lpstr>宋体</vt:lpstr>
      <vt:lpstr>Arial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MDPI</cp:lastModifiedBy>
  <cp:revision>143</cp:revision>
  <cp:lastPrinted>2021-06-24T10:45:14Z</cp:lastPrinted>
  <dcterms:created xsi:type="dcterms:W3CDTF">2020-05-04T02:40:41Z</dcterms:created>
  <dcterms:modified xsi:type="dcterms:W3CDTF">2021-10-22T05:35:44Z</dcterms:modified>
</cp:coreProperties>
</file>